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  <p:sldId id="263" r:id="rId3"/>
    <p:sldId id="268" r:id="rId4"/>
    <p:sldId id="26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3120" y="-6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15matsubara" userId="dd2ea628-74e6-45e1-a47e-522117d2ea3a" providerId="ADAL" clId="{C6C412C4-6624-4302-955C-D6C081F0BD65}"/>
    <pc:docChg chg="undo custSel addSld delSld modSld">
      <pc:chgData name="r15matsubara" userId="dd2ea628-74e6-45e1-a47e-522117d2ea3a" providerId="ADAL" clId="{C6C412C4-6624-4302-955C-D6C081F0BD65}" dt="2026-03-09T09:41:23.220" v="795" actId="1037"/>
      <pc:docMkLst>
        <pc:docMk/>
      </pc:docMkLst>
      <pc:sldChg chg="addSp delSp modSp mod">
        <pc:chgData name="r15matsubara" userId="dd2ea628-74e6-45e1-a47e-522117d2ea3a" providerId="ADAL" clId="{C6C412C4-6624-4302-955C-D6C081F0BD65}" dt="2026-03-09T02:47:06.123" v="712" actId="1076"/>
        <pc:sldMkLst>
          <pc:docMk/>
          <pc:sldMk cId="801831214" sldId="268"/>
        </pc:sldMkLst>
        <pc:spChg chg="mod">
          <ac:chgData name="r15matsubara" userId="dd2ea628-74e6-45e1-a47e-522117d2ea3a" providerId="ADAL" clId="{C6C412C4-6624-4302-955C-D6C081F0BD65}" dt="2026-03-09T02:47:06.123" v="712" actId="1076"/>
          <ac:spMkLst>
            <pc:docMk/>
            <pc:sldMk cId="801831214" sldId="268"/>
            <ac:spMk id="16" creationId="{7B9DDCB0-4F04-E631-A927-18C4D5A388D3}"/>
          </ac:spMkLst>
        </pc:spChg>
        <pc:spChg chg="mod">
          <ac:chgData name="r15matsubara" userId="dd2ea628-74e6-45e1-a47e-522117d2ea3a" providerId="ADAL" clId="{C6C412C4-6624-4302-955C-D6C081F0BD65}" dt="2026-03-09T02:47:06.123" v="712" actId="1076"/>
          <ac:spMkLst>
            <pc:docMk/>
            <pc:sldMk cId="801831214" sldId="268"/>
            <ac:spMk id="17" creationId="{A0CEE7CE-3274-BADC-490F-C20F20650B0B}"/>
          </ac:spMkLst>
        </pc:spChg>
        <pc:spChg chg="mod">
          <ac:chgData name="r15matsubara" userId="dd2ea628-74e6-45e1-a47e-522117d2ea3a" providerId="ADAL" clId="{C6C412C4-6624-4302-955C-D6C081F0BD65}" dt="2026-03-09T02:47:06.123" v="712" actId="1076"/>
          <ac:spMkLst>
            <pc:docMk/>
            <pc:sldMk cId="801831214" sldId="268"/>
            <ac:spMk id="18" creationId="{A3E117D8-F5DC-0D5F-1CA6-83266E8D83A2}"/>
          </ac:spMkLst>
        </pc:spChg>
        <pc:spChg chg="mod">
          <ac:chgData name="r15matsubara" userId="dd2ea628-74e6-45e1-a47e-522117d2ea3a" providerId="ADAL" clId="{C6C412C4-6624-4302-955C-D6C081F0BD65}" dt="2026-03-09T02:47:06.123" v="712" actId="1076"/>
          <ac:spMkLst>
            <pc:docMk/>
            <pc:sldMk cId="801831214" sldId="268"/>
            <ac:spMk id="19" creationId="{29DC3FD1-4282-5782-1CD2-52656E766EB2}"/>
          </ac:spMkLst>
        </pc:spChg>
        <pc:spChg chg="mod">
          <ac:chgData name="r15matsubara" userId="dd2ea628-74e6-45e1-a47e-522117d2ea3a" providerId="ADAL" clId="{C6C412C4-6624-4302-955C-D6C081F0BD65}" dt="2026-03-09T02:47:06.123" v="712" actId="1076"/>
          <ac:spMkLst>
            <pc:docMk/>
            <pc:sldMk cId="801831214" sldId="268"/>
            <ac:spMk id="20" creationId="{C93925DE-5087-C27B-2964-732736BF3841}"/>
          </ac:spMkLst>
        </pc:spChg>
        <pc:spChg chg="mod">
          <ac:chgData name="r15matsubara" userId="dd2ea628-74e6-45e1-a47e-522117d2ea3a" providerId="ADAL" clId="{C6C412C4-6624-4302-955C-D6C081F0BD65}" dt="2026-03-09T02:47:06.123" v="712" actId="1076"/>
          <ac:spMkLst>
            <pc:docMk/>
            <pc:sldMk cId="801831214" sldId="268"/>
            <ac:spMk id="26" creationId="{6F7A851B-CBAA-9BA0-6E5F-C27EBF19F416}"/>
          </ac:spMkLst>
        </pc:spChg>
        <pc:spChg chg="mod">
          <ac:chgData name="r15matsubara" userId="dd2ea628-74e6-45e1-a47e-522117d2ea3a" providerId="ADAL" clId="{C6C412C4-6624-4302-955C-D6C081F0BD65}" dt="2026-03-09T02:47:06.123" v="712" actId="1076"/>
          <ac:spMkLst>
            <pc:docMk/>
            <pc:sldMk cId="801831214" sldId="268"/>
            <ac:spMk id="27" creationId="{0C43F555-5EC9-3AEF-90C2-0D3F7F1163E6}"/>
          </ac:spMkLst>
        </pc:spChg>
        <pc:spChg chg="mod">
          <ac:chgData name="r15matsubara" userId="dd2ea628-74e6-45e1-a47e-522117d2ea3a" providerId="ADAL" clId="{C6C412C4-6624-4302-955C-D6C081F0BD65}" dt="2026-03-09T02:47:06.123" v="712" actId="1076"/>
          <ac:spMkLst>
            <pc:docMk/>
            <pc:sldMk cId="801831214" sldId="268"/>
            <ac:spMk id="28" creationId="{4AE527F0-5ADE-9D87-2E09-8E0E3C0549D6}"/>
          </ac:spMkLst>
        </pc:spChg>
        <pc:spChg chg="mod">
          <ac:chgData name="r15matsubara" userId="dd2ea628-74e6-45e1-a47e-522117d2ea3a" providerId="ADAL" clId="{C6C412C4-6624-4302-955C-D6C081F0BD65}" dt="2026-03-09T02:47:06.123" v="712" actId="1076"/>
          <ac:spMkLst>
            <pc:docMk/>
            <pc:sldMk cId="801831214" sldId="268"/>
            <ac:spMk id="29" creationId="{E6F4CC27-7368-6B6D-F8EA-A617EC4CC1B4}"/>
          </ac:spMkLst>
        </pc:spChg>
        <pc:spChg chg="mod">
          <ac:chgData name="r15matsubara" userId="dd2ea628-74e6-45e1-a47e-522117d2ea3a" providerId="ADAL" clId="{C6C412C4-6624-4302-955C-D6C081F0BD65}" dt="2026-03-09T02:47:06.123" v="712" actId="1076"/>
          <ac:spMkLst>
            <pc:docMk/>
            <pc:sldMk cId="801831214" sldId="268"/>
            <ac:spMk id="34" creationId="{58D4B7CC-FA6D-6D6D-4609-BBC4E86CE3A8}"/>
          </ac:spMkLst>
        </pc:spChg>
        <pc:spChg chg="add mod">
          <ac:chgData name="r15matsubara" userId="dd2ea628-74e6-45e1-a47e-522117d2ea3a" providerId="ADAL" clId="{C6C412C4-6624-4302-955C-D6C081F0BD65}" dt="2026-03-09T02:46:23.413" v="705" actId="553"/>
          <ac:spMkLst>
            <pc:docMk/>
            <pc:sldMk cId="801831214" sldId="268"/>
            <ac:spMk id="42" creationId="{F05C4F43-2A68-73C8-98F4-53C06F1BD67F}"/>
          </ac:spMkLst>
        </pc:spChg>
        <pc:spChg chg="add mod">
          <ac:chgData name="r15matsubara" userId="dd2ea628-74e6-45e1-a47e-522117d2ea3a" providerId="ADAL" clId="{C6C412C4-6624-4302-955C-D6C081F0BD65}" dt="2026-03-09T02:46:55.793" v="711" actId="1076"/>
          <ac:spMkLst>
            <pc:docMk/>
            <pc:sldMk cId="801831214" sldId="268"/>
            <ac:spMk id="43" creationId="{7A26B8E0-927C-F26B-2AA1-3FE78B2C5EF4}"/>
          </ac:spMkLst>
        </pc:spChg>
        <pc:spChg chg="add mod">
          <ac:chgData name="r15matsubara" userId="dd2ea628-74e6-45e1-a47e-522117d2ea3a" providerId="ADAL" clId="{C6C412C4-6624-4302-955C-D6C081F0BD65}" dt="2026-03-09T02:46:55.793" v="711" actId="1076"/>
          <ac:spMkLst>
            <pc:docMk/>
            <pc:sldMk cId="801831214" sldId="268"/>
            <ac:spMk id="44" creationId="{7DB91034-AF8A-2254-BD94-DBCF7D7473FC}"/>
          </ac:spMkLst>
        </pc:spChg>
        <pc:spChg chg="add mod">
          <ac:chgData name="r15matsubara" userId="dd2ea628-74e6-45e1-a47e-522117d2ea3a" providerId="ADAL" clId="{C6C412C4-6624-4302-955C-D6C081F0BD65}" dt="2026-03-09T02:46:23.413" v="705" actId="553"/>
          <ac:spMkLst>
            <pc:docMk/>
            <pc:sldMk cId="801831214" sldId="268"/>
            <ac:spMk id="45" creationId="{AE8C6660-6671-39ED-F4A2-E9BAB28827FC}"/>
          </ac:spMkLst>
        </pc:spChg>
        <pc:spChg chg="add mod">
          <ac:chgData name="r15matsubara" userId="dd2ea628-74e6-45e1-a47e-522117d2ea3a" providerId="ADAL" clId="{C6C412C4-6624-4302-955C-D6C081F0BD65}" dt="2026-03-09T02:46:23.413" v="705" actId="553"/>
          <ac:spMkLst>
            <pc:docMk/>
            <pc:sldMk cId="801831214" sldId="268"/>
            <ac:spMk id="46" creationId="{8FA31FCA-E814-9C02-5D47-8AC5FDB22895}"/>
          </ac:spMkLst>
        </pc:spChg>
        <pc:spChg chg="add mod">
          <ac:chgData name="r15matsubara" userId="dd2ea628-74e6-45e1-a47e-522117d2ea3a" providerId="ADAL" clId="{C6C412C4-6624-4302-955C-D6C081F0BD65}" dt="2026-03-09T02:46:55.793" v="711" actId="1076"/>
          <ac:spMkLst>
            <pc:docMk/>
            <pc:sldMk cId="801831214" sldId="268"/>
            <ac:spMk id="47" creationId="{066494A4-FD91-72A6-85BB-01332CA1210D}"/>
          </ac:spMkLst>
        </pc:spChg>
        <pc:spChg chg="add mod">
          <ac:chgData name="r15matsubara" userId="dd2ea628-74e6-45e1-a47e-522117d2ea3a" providerId="ADAL" clId="{C6C412C4-6624-4302-955C-D6C081F0BD65}" dt="2026-03-09T02:46:55.793" v="711" actId="1076"/>
          <ac:spMkLst>
            <pc:docMk/>
            <pc:sldMk cId="801831214" sldId="268"/>
            <ac:spMk id="48" creationId="{5F230778-4CB5-900A-E381-B0AD319B71F0}"/>
          </ac:spMkLst>
        </pc:spChg>
        <pc:spChg chg="add del mod">
          <ac:chgData name="r15matsubara" userId="dd2ea628-74e6-45e1-a47e-522117d2ea3a" providerId="ADAL" clId="{C6C412C4-6624-4302-955C-D6C081F0BD65}" dt="2026-03-09T02:45:20.474" v="689" actId="478"/>
          <ac:spMkLst>
            <pc:docMk/>
            <pc:sldMk cId="801831214" sldId="268"/>
            <ac:spMk id="49" creationId="{5C2617FA-D777-392F-F56B-93068D15ACEA}"/>
          </ac:spMkLst>
        </pc:spChg>
        <pc:spChg chg="add del mod">
          <ac:chgData name="r15matsubara" userId="dd2ea628-74e6-45e1-a47e-522117d2ea3a" providerId="ADAL" clId="{C6C412C4-6624-4302-955C-D6C081F0BD65}" dt="2026-03-09T02:45:21.324" v="690" actId="478"/>
          <ac:spMkLst>
            <pc:docMk/>
            <pc:sldMk cId="801831214" sldId="268"/>
            <ac:spMk id="50" creationId="{757CA4F0-ECC8-9E0E-3DC5-B521DEF7AA6F}"/>
          </ac:spMkLst>
        </pc:spChg>
        <pc:spChg chg="add mod">
          <ac:chgData name="r15matsubara" userId="dd2ea628-74e6-45e1-a47e-522117d2ea3a" providerId="ADAL" clId="{C6C412C4-6624-4302-955C-D6C081F0BD65}" dt="2026-03-09T02:46:46.230" v="709" actId="14100"/>
          <ac:spMkLst>
            <pc:docMk/>
            <pc:sldMk cId="801831214" sldId="268"/>
            <ac:spMk id="51" creationId="{42AE1607-BF3E-2BAC-5DF5-869920D67312}"/>
          </ac:spMkLst>
        </pc:spChg>
        <pc:spChg chg="add mod">
          <ac:chgData name="r15matsubara" userId="dd2ea628-74e6-45e1-a47e-522117d2ea3a" providerId="ADAL" clId="{C6C412C4-6624-4302-955C-D6C081F0BD65}" dt="2026-03-09T02:46:55.793" v="711" actId="1076"/>
          <ac:spMkLst>
            <pc:docMk/>
            <pc:sldMk cId="801831214" sldId="268"/>
            <ac:spMk id="52" creationId="{B4BF7CAB-BF39-832B-7E2E-0F57BE48C16E}"/>
          </ac:spMkLst>
        </pc:spChg>
        <pc:spChg chg="add mod">
          <ac:chgData name="r15matsubara" userId="dd2ea628-74e6-45e1-a47e-522117d2ea3a" providerId="ADAL" clId="{C6C412C4-6624-4302-955C-D6C081F0BD65}" dt="2026-03-09T02:46:55.793" v="711" actId="1076"/>
          <ac:spMkLst>
            <pc:docMk/>
            <pc:sldMk cId="801831214" sldId="268"/>
            <ac:spMk id="53" creationId="{3D37094D-E308-FEC8-DCC1-985B07CB7910}"/>
          </ac:spMkLst>
        </pc:spChg>
        <pc:spChg chg="add mod">
          <ac:chgData name="r15matsubara" userId="dd2ea628-74e6-45e1-a47e-522117d2ea3a" providerId="ADAL" clId="{C6C412C4-6624-4302-955C-D6C081F0BD65}" dt="2026-03-09T02:46:55.793" v="711" actId="1076"/>
          <ac:spMkLst>
            <pc:docMk/>
            <pc:sldMk cId="801831214" sldId="268"/>
            <ac:spMk id="54" creationId="{B7C4B296-E222-7BA6-75D5-2C0189985F2C}"/>
          </ac:spMkLst>
        </pc:spChg>
        <pc:spChg chg="add mod">
          <ac:chgData name="r15matsubara" userId="dd2ea628-74e6-45e1-a47e-522117d2ea3a" providerId="ADAL" clId="{C6C412C4-6624-4302-955C-D6C081F0BD65}" dt="2026-03-09T02:46:55.793" v="711" actId="1076"/>
          <ac:spMkLst>
            <pc:docMk/>
            <pc:sldMk cId="801831214" sldId="268"/>
            <ac:spMk id="55" creationId="{AE69C909-1F52-47B7-D1A3-580C0D286F93}"/>
          </ac:spMkLst>
        </pc:spChg>
        <pc:spChg chg="add mod">
          <ac:chgData name="r15matsubara" userId="dd2ea628-74e6-45e1-a47e-522117d2ea3a" providerId="ADAL" clId="{C6C412C4-6624-4302-955C-D6C081F0BD65}" dt="2026-03-09T02:46:40.734" v="707" actId="1076"/>
          <ac:spMkLst>
            <pc:docMk/>
            <pc:sldMk cId="801831214" sldId="268"/>
            <ac:spMk id="56" creationId="{049CAEEE-0DEB-3475-FBAC-7424312F86A3}"/>
          </ac:spMkLst>
        </pc:spChg>
        <pc:spChg chg="add mod">
          <ac:chgData name="r15matsubara" userId="dd2ea628-74e6-45e1-a47e-522117d2ea3a" providerId="ADAL" clId="{C6C412C4-6624-4302-955C-D6C081F0BD65}" dt="2026-03-09T02:46:55.793" v="711" actId="1076"/>
          <ac:spMkLst>
            <pc:docMk/>
            <pc:sldMk cId="801831214" sldId="268"/>
            <ac:spMk id="59" creationId="{3B1BF858-FB6B-C1A3-A9A0-E3A0D8C7AF51}"/>
          </ac:spMkLst>
        </pc:spChg>
        <pc:spChg chg="add mod">
          <ac:chgData name="r15matsubara" userId="dd2ea628-74e6-45e1-a47e-522117d2ea3a" providerId="ADAL" clId="{C6C412C4-6624-4302-955C-D6C081F0BD65}" dt="2026-03-09T02:46:55.793" v="711" actId="1076"/>
          <ac:spMkLst>
            <pc:docMk/>
            <pc:sldMk cId="801831214" sldId="268"/>
            <ac:spMk id="60" creationId="{DDB16625-EA4B-27C2-CE92-89A26C2EE25F}"/>
          </ac:spMkLst>
        </pc:spChg>
        <pc:spChg chg="add mod">
          <ac:chgData name="r15matsubara" userId="dd2ea628-74e6-45e1-a47e-522117d2ea3a" providerId="ADAL" clId="{C6C412C4-6624-4302-955C-D6C081F0BD65}" dt="2026-03-07T06:53:03.067" v="351" actId="1035"/>
          <ac:spMkLst>
            <pc:docMk/>
            <pc:sldMk cId="801831214" sldId="268"/>
            <ac:spMk id="73" creationId="{3851E8D4-D05D-4577-5BC7-194D2A46F0D0}"/>
          </ac:spMkLst>
        </pc:spChg>
        <pc:spChg chg="add mod">
          <ac:chgData name="r15matsubara" userId="dd2ea628-74e6-45e1-a47e-522117d2ea3a" providerId="ADAL" clId="{C6C412C4-6624-4302-955C-D6C081F0BD65}" dt="2026-03-07T06:53:03.067" v="351" actId="1035"/>
          <ac:spMkLst>
            <pc:docMk/>
            <pc:sldMk cId="801831214" sldId="268"/>
            <ac:spMk id="74" creationId="{125EB4BD-1972-412D-A020-838F9F1DFB7E}"/>
          </ac:spMkLst>
        </pc:spChg>
        <pc:spChg chg="add mod">
          <ac:chgData name="r15matsubara" userId="dd2ea628-74e6-45e1-a47e-522117d2ea3a" providerId="ADAL" clId="{C6C412C4-6624-4302-955C-D6C081F0BD65}" dt="2026-03-07T06:51:41.150" v="279" actId="1076"/>
          <ac:spMkLst>
            <pc:docMk/>
            <pc:sldMk cId="801831214" sldId="268"/>
            <ac:spMk id="75" creationId="{1D23E9D6-1D98-37B9-A7EE-50C561590796}"/>
          </ac:spMkLst>
        </pc:spChg>
        <pc:spChg chg="add mod">
          <ac:chgData name="r15matsubara" userId="dd2ea628-74e6-45e1-a47e-522117d2ea3a" providerId="ADAL" clId="{C6C412C4-6624-4302-955C-D6C081F0BD65}" dt="2026-03-07T06:53:03.067" v="351" actId="1035"/>
          <ac:spMkLst>
            <pc:docMk/>
            <pc:sldMk cId="801831214" sldId="268"/>
            <ac:spMk id="76" creationId="{642DFD81-790A-A826-60E5-3B91085500B2}"/>
          </ac:spMkLst>
        </pc:spChg>
        <pc:spChg chg="add mod">
          <ac:chgData name="r15matsubara" userId="dd2ea628-74e6-45e1-a47e-522117d2ea3a" providerId="ADAL" clId="{C6C412C4-6624-4302-955C-D6C081F0BD65}" dt="2026-03-07T06:51:49.336" v="311" actId="1035"/>
          <ac:spMkLst>
            <pc:docMk/>
            <pc:sldMk cId="801831214" sldId="268"/>
            <ac:spMk id="77" creationId="{976C9779-05E3-4025-ABA6-44431729401A}"/>
          </ac:spMkLst>
        </pc:spChg>
        <pc:spChg chg="add mod">
          <ac:chgData name="r15matsubara" userId="dd2ea628-74e6-45e1-a47e-522117d2ea3a" providerId="ADAL" clId="{C6C412C4-6624-4302-955C-D6C081F0BD65}" dt="2026-03-07T06:53:03.067" v="351" actId="1035"/>
          <ac:spMkLst>
            <pc:docMk/>
            <pc:sldMk cId="801831214" sldId="268"/>
            <ac:spMk id="78" creationId="{E9DB81AD-2B19-F1C7-BEDB-1D1D5775EADB}"/>
          </ac:spMkLst>
        </pc:spChg>
        <pc:spChg chg="add mod">
          <ac:chgData name="r15matsubara" userId="dd2ea628-74e6-45e1-a47e-522117d2ea3a" providerId="ADAL" clId="{C6C412C4-6624-4302-955C-D6C081F0BD65}" dt="2026-03-07T06:51:27.156" v="277" actId="1076"/>
          <ac:spMkLst>
            <pc:docMk/>
            <pc:sldMk cId="801831214" sldId="268"/>
            <ac:spMk id="79" creationId="{87510CBA-E70D-F408-CD58-3A59A162D69E}"/>
          </ac:spMkLst>
        </pc:spChg>
        <pc:spChg chg="add mod">
          <ac:chgData name="r15matsubara" userId="dd2ea628-74e6-45e1-a47e-522117d2ea3a" providerId="ADAL" clId="{C6C412C4-6624-4302-955C-D6C081F0BD65}" dt="2026-03-07T06:51:58.011" v="315" actId="1076"/>
          <ac:spMkLst>
            <pc:docMk/>
            <pc:sldMk cId="801831214" sldId="268"/>
            <ac:spMk id="80" creationId="{11790461-69A8-2B91-D539-D672A55B0F7C}"/>
          </ac:spMkLst>
        </pc:spChg>
        <pc:spChg chg="add mod">
          <ac:chgData name="r15matsubara" userId="dd2ea628-74e6-45e1-a47e-522117d2ea3a" providerId="ADAL" clId="{C6C412C4-6624-4302-955C-D6C081F0BD65}" dt="2026-03-07T06:53:03.067" v="351" actId="1035"/>
          <ac:spMkLst>
            <pc:docMk/>
            <pc:sldMk cId="801831214" sldId="268"/>
            <ac:spMk id="81" creationId="{60DCFD21-E075-C2E5-C7D8-0E6B0D8C29A6}"/>
          </ac:spMkLst>
        </pc:spChg>
        <pc:spChg chg="add mod">
          <ac:chgData name="r15matsubara" userId="dd2ea628-74e6-45e1-a47e-522117d2ea3a" providerId="ADAL" clId="{C6C412C4-6624-4302-955C-D6C081F0BD65}" dt="2026-03-07T06:53:14.364" v="354" actId="1076"/>
          <ac:spMkLst>
            <pc:docMk/>
            <pc:sldMk cId="801831214" sldId="268"/>
            <ac:spMk id="82" creationId="{8598E254-8DCE-39EB-F0BF-B9574917632E}"/>
          </ac:spMkLst>
        </pc:spChg>
        <pc:spChg chg="add mod">
          <ac:chgData name="r15matsubara" userId="dd2ea628-74e6-45e1-a47e-522117d2ea3a" providerId="ADAL" clId="{C6C412C4-6624-4302-955C-D6C081F0BD65}" dt="2026-03-07T06:53:03.067" v="351" actId="1035"/>
          <ac:spMkLst>
            <pc:docMk/>
            <pc:sldMk cId="801831214" sldId="268"/>
            <ac:spMk id="83" creationId="{EA643FDD-91DA-C4A1-88A9-1A242D0912B7}"/>
          </ac:spMkLst>
        </pc:spChg>
        <pc:spChg chg="add mod">
          <ac:chgData name="r15matsubara" userId="dd2ea628-74e6-45e1-a47e-522117d2ea3a" providerId="ADAL" clId="{C6C412C4-6624-4302-955C-D6C081F0BD65}" dt="2026-03-07T06:53:03.067" v="351" actId="1035"/>
          <ac:spMkLst>
            <pc:docMk/>
            <pc:sldMk cId="801831214" sldId="268"/>
            <ac:spMk id="84" creationId="{C973346D-941B-C0CC-A520-6AF0779DCEC5}"/>
          </ac:spMkLst>
        </pc:spChg>
        <pc:spChg chg="add mod">
          <ac:chgData name="r15matsubara" userId="dd2ea628-74e6-45e1-a47e-522117d2ea3a" providerId="ADAL" clId="{C6C412C4-6624-4302-955C-D6C081F0BD65}" dt="2026-03-07T06:53:03.067" v="351" actId="1035"/>
          <ac:spMkLst>
            <pc:docMk/>
            <pc:sldMk cId="801831214" sldId="268"/>
            <ac:spMk id="85" creationId="{4627A3AC-997D-F37D-7BE6-E59554C8D79A}"/>
          </ac:spMkLst>
        </pc:spChg>
        <pc:spChg chg="add mod">
          <ac:chgData name="r15matsubara" userId="dd2ea628-74e6-45e1-a47e-522117d2ea3a" providerId="ADAL" clId="{C6C412C4-6624-4302-955C-D6C081F0BD65}" dt="2026-03-07T06:53:03.067" v="351" actId="1035"/>
          <ac:spMkLst>
            <pc:docMk/>
            <pc:sldMk cId="801831214" sldId="268"/>
            <ac:spMk id="86" creationId="{9E771820-37CE-0314-7F21-538A955D2D95}"/>
          </ac:spMkLst>
        </pc:spChg>
        <pc:spChg chg="add mod">
          <ac:chgData name="r15matsubara" userId="dd2ea628-74e6-45e1-a47e-522117d2ea3a" providerId="ADAL" clId="{C6C412C4-6624-4302-955C-D6C081F0BD65}" dt="2026-03-07T06:52:13.778" v="318" actId="1076"/>
          <ac:spMkLst>
            <pc:docMk/>
            <pc:sldMk cId="801831214" sldId="268"/>
            <ac:spMk id="87" creationId="{1D507131-CD58-C20F-DD28-59C4FF493B8D}"/>
          </ac:spMkLst>
        </pc:spChg>
        <pc:spChg chg="add mod">
          <ac:chgData name="r15matsubara" userId="dd2ea628-74e6-45e1-a47e-522117d2ea3a" providerId="ADAL" clId="{C6C412C4-6624-4302-955C-D6C081F0BD65}" dt="2026-03-07T06:52:13.778" v="318" actId="1076"/>
          <ac:spMkLst>
            <pc:docMk/>
            <pc:sldMk cId="801831214" sldId="268"/>
            <ac:spMk id="90" creationId="{BE3319DC-444A-AA40-6FCE-D5AB97865B7E}"/>
          </ac:spMkLst>
        </pc:spChg>
        <pc:spChg chg="add mod">
          <ac:chgData name="r15matsubara" userId="dd2ea628-74e6-45e1-a47e-522117d2ea3a" providerId="ADAL" clId="{C6C412C4-6624-4302-955C-D6C081F0BD65}" dt="2026-03-07T06:53:08.809" v="353" actId="1076"/>
          <ac:spMkLst>
            <pc:docMk/>
            <pc:sldMk cId="801831214" sldId="268"/>
            <ac:spMk id="92" creationId="{C2C234F2-F1EC-2FD9-1449-C25C256E8776}"/>
          </ac:spMkLst>
        </pc:spChg>
        <pc:spChg chg="add mod">
          <ac:chgData name="r15matsubara" userId="dd2ea628-74e6-45e1-a47e-522117d2ea3a" providerId="ADAL" clId="{C6C412C4-6624-4302-955C-D6C081F0BD65}" dt="2026-03-07T06:53:08.809" v="353" actId="1076"/>
          <ac:spMkLst>
            <pc:docMk/>
            <pc:sldMk cId="801831214" sldId="268"/>
            <ac:spMk id="93" creationId="{752D5953-A4E5-D025-71A3-A4955DE166BB}"/>
          </ac:spMkLst>
        </pc:spChg>
        <pc:spChg chg="add mod">
          <ac:chgData name="r15matsubara" userId="dd2ea628-74e6-45e1-a47e-522117d2ea3a" providerId="ADAL" clId="{C6C412C4-6624-4302-955C-D6C081F0BD65}" dt="2026-03-07T07:13:34.786" v="538" actId="1076"/>
          <ac:spMkLst>
            <pc:docMk/>
            <pc:sldMk cId="801831214" sldId="268"/>
            <ac:spMk id="94" creationId="{D6FB2FEC-BCDC-1DEE-0A03-1FACBDEF32DF}"/>
          </ac:spMkLst>
        </pc:spChg>
        <pc:picChg chg="add mod ord modCrop">
          <ac:chgData name="r15matsubara" userId="dd2ea628-74e6-45e1-a47e-522117d2ea3a" providerId="ADAL" clId="{C6C412C4-6624-4302-955C-D6C081F0BD65}" dt="2026-03-09T02:45:46.139" v="697" actId="1076"/>
          <ac:picMkLst>
            <pc:docMk/>
            <pc:sldMk cId="801831214" sldId="268"/>
            <ac:picMk id="3" creationId="{AEC29A36-8B53-4E50-1E76-1376E567FAEB}"/>
          </ac:picMkLst>
        </pc:picChg>
        <pc:picChg chg="add mod ord modCrop">
          <ac:chgData name="r15matsubara" userId="dd2ea628-74e6-45e1-a47e-522117d2ea3a" providerId="ADAL" clId="{C6C412C4-6624-4302-955C-D6C081F0BD65}" dt="2026-03-09T02:45:39.179" v="696" actId="1076"/>
          <ac:picMkLst>
            <pc:docMk/>
            <pc:sldMk cId="801831214" sldId="268"/>
            <ac:picMk id="5" creationId="{0EFD8AF1-02AA-DCD4-9479-1340F41F7ECC}"/>
          </ac:picMkLst>
        </pc:picChg>
        <pc:picChg chg="mod modCrop">
          <ac:chgData name="r15matsubara" userId="dd2ea628-74e6-45e1-a47e-522117d2ea3a" providerId="ADAL" clId="{C6C412C4-6624-4302-955C-D6C081F0BD65}" dt="2026-03-07T06:35:08.190" v="40" actId="18131"/>
          <ac:picMkLst>
            <pc:docMk/>
            <pc:sldMk cId="801831214" sldId="268"/>
            <ac:picMk id="7" creationId="{2C774366-0AEF-2DCA-8C5B-BB3B3B632365}"/>
          </ac:picMkLst>
        </pc:picChg>
        <pc:picChg chg="add mod modCrop">
          <ac:chgData name="r15matsubara" userId="dd2ea628-74e6-45e1-a47e-522117d2ea3a" providerId="ADAL" clId="{C6C412C4-6624-4302-955C-D6C081F0BD65}" dt="2026-03-07T06:34:46.516" v="38" actId="1076"/>
          <ac:picMkLst>
            <pc:docMk/>
            <pc:sldMk cId="801831214" sldId="268"/>
            <ac:picMk id="36" creationId="{CAC9945F-9D09-5234-693C-97C8017CB683}"/>
          </ac:picMkLst>
        </pc:picChg>
        <pc:picChg chg="add mod modCrop">
          <ac:chgData name="r15matsubara" userId="dd2ea628-74e6-45e1-a47e-522117d2ea3a" providerId="ADAL" clId="{C6C412C4-6624-4302-955C-D6C081F0BD65}" dt="2026-03-07T06:33:51.455" v="27" actId="14100"/>
          <ac:picMkLst>
            <pc:docMk/>
            <pc:sldMk cId="801831214" sldId="268"/>
            <ac:picMk id="38" creationId="{4DF117CA-24FC-C2E8-BFEC-B052C0721224}"/>
          </ac:picMkLst>
        </pc:picChg>
        <pc:picChg chg="add del mod">
          <ac:chgData name="r15matsubara" userId="dd2ea628-74e6-45e1-a47e-522117d2ea3a" providerId="ADAL" clId="{C6C412C4-6624-4302-955C-D6C081F0BD65}" dt="2026-03-09T02:43:45.888" v="670" actId="478"/>
          <ac:picMkLst>
            <pc:docMk/>
            <pc:sldMk cId="801831214" sldId="268"/>
            <ac:picMk id="39" creationId="{4997556A-3BFF-8540-FD0E-F2A53042C318}"/>
          </ac:picMkLst>
        </pc:picChg>
        <pc:picChg chg="add del mod">
          <ac:chgData name="r15matsubara" userId="dd2ea628-74e6-45e1-a47e-522117d2ea3a" providerId="ADAL" clId="{C6C412C4-6624-4302-955C-D6C081F0BD65}" dt="2026-03-09T02:43:45.888" v="670" actId="478"/>
          <ac:picMkLst>
            <pc:docMk/>
            <pc:sldMk cId="801831214" sldId="268"/>
            <ac:picMk id="40" creationId="{5A1C36F0-121D-1FEA-19B5-E0FD34331664}"/>
          </ac:picMkLst>
        </pc:picChg>
        <pc:picChg chg="add del mod">
          <ac:chgData name="r15matsubara" userId="dd2ea628-74e6-45e1-a47e-522117d2ea3a" providerId="ADAL" clId="{C6C412C4-6624-4302-955C-D6C081F0BD65}" dt="2026-03-09T02:43:45.888" v="670" actId="478"/>
          <ac:picMkLst>
            <pc:docMk/>
            <pc:sldMk cId="801831214" sldId="268"/>
            <ac:picMk id="41" creationId="{D2B23913-CE04-5E60-4E2F-278A6D2E06FF}"/>
          </ac:picMkLst>
        </pc:picChg>
        <pc:picChg chg="add mod modCrop">
          <ac:chgData name="r15matsubara" userId="dd2ea628-74e6-45e1-a47e-522117d2ea3a" providerId="ADAL" clId="{C6C412C4-6624-4302-955C-D6C081F0BD65}" dt="2026-03-07T06:51:10.616" v="273" actId="1076"/>
          <ac:picMkLst>
            <pc:docMk/>
            <pc:sldMk cId="801831214" sldId="268"/>
            <ac:picMk id="63" creationId="{8E5A910C-65AF-8C69-6538-4A89E5E2DEE0}"/>
          </ac:picMkLst>
        </pc:picChg>
        <pc:picChg chg="add mod modCrop">
          <ac:chgData name="r15matsubara" userId="dd2ea628-74e6-45e1-a47e-522117d2ea3a" providerId="ADAL" clId="{C6C412C4-6624-4302-955C-D6C081F0BD65}" dt="2026-03-07T06:51:09.109" v="272" actId="1076"/>
          <ac:picMkLst>
            <pc:docMk/>
            <pc:sldMk cId="801831214" sldId="268"/>
            <ac:picMk id="69" creationId="{A8B1AA2D-8288-757D-C41D-8AC14D166508}"/>
          </ac:picMkLst>
        </pc:picChg>
        <pc:picChg chg="add mod modCrop">
          <ac:chgData name="r15matsubara" userId="dd2ea628-74e6-45e1-a47e-522117d2ea3a" providerId="ADAL" clId="{C6C412C4-6624-4302-955C-D6C081F0BD65}" dt="2026-03-07T06:51:09.109" v="272" actId="1076"/>
          <ac:picMkLst>
            <pc:docMk/>
            <pc:sldMk cId="801831214" sldId="268"/>
            <ac:picMk id="71" creationId="{478A01F1-0CFB-7E22-888A-86805BAC673A}"/>
          </ac:picMkLst>
        </pc:picChg>
        <pc:cxnChg chg="mod">
          <ac:chgData name="r15matsubara" userId="dd2ea628-74e6-45e1-a47e-522117d2ea3a" providerId="ADAL" clId="{C6C412C4-6624-4302-955C-D6C081F0BD65}" dt="2026-03-07T06:35:11.093" v="41" actId="1076"/>
          <ac:cxnSpMkLst>
            <pc:docMk/>
            <pc:sldMk cId="801831214" sldId="268"/>
            <ac:cxnSpMk id="32" creationId="{3CA720A0-B224-4807-34F4-9081CC585769}"/>
          </ac:cxnSpMkLst>
        </pc:cxnChg>
        <pc:cxnChg chg="add mod">
          <ac:chgData name="r15matsubara" userId="dd2ea628-74e6-45e1-a47e-522117d2ea3a" providerId="ADAL" clId="{C6C412C4-6624-4302-955C-D6C081F0BD65}" dt="2026-03-09T02:46:40.734" v="707" actId="1076"/>
          <ac:cxnSpMkLst>
            <pc:docMk/>
            <pc:sldMk cId="801831214" sldId="268"/>
            <ac:cxnSpMk id="57" creationId="{ADE8963A-8DA1-9A56-FDD2-0399C8867071}"/>
          </ac:cxnSpMkLst>
        </pc:cxnChg>
        <pc:cxnChg chg="add mod">
          <ac:chgData name="r15matsubara" userId="dd2ea628-74e6-45e1-a47e-522117d2ea3a" providerId="ADAL" clId="{C6C412C4-6624-4302-955C-D6C081F0BD65}" dt="2026-03-09T02:46:40.734" v="707" actId="1076"/>
          <ac:cxnSpMkLst>
            <pc:docMk/>
            <pc:sldMk cId="801831214" sldId="268"/>
            <ac:cxnSpMk id="58" creationId="{B70F0E1D-0D63-459E-8EF4-9676B400FAF2}"/>
          </ac:cxnSpMkLst>
        </pc:cxnChg>
        <pc:cxnChg chg="add mod">
          <ac:chgData name="r15matsubara" userId="dd2ea628-74e6-45e1-a47e-522117d2ea3a" providerId="ADAL" clId="{C6C412C4-6624-4302-955C-D6C081F0BD65}" dt="2026-03-09T02:46:49.935" v="710" actId="1076"/>
          <ac:cxnSpMkLst>
            <pc:docMk/>
            <pc:sldMk cId="801831214" sldId="268"/>
            <ac:cxnSpMk id="61" creationId="{CD3E57A5-BDFC-6B51-0EDF-D00A9DECBB8A}"/>
          </ac:cxnSpMkLst>
        </pc:cxnChg>
        <pc:cxnChg chg="add mod">
          <ac:chgData name="r15matsubara" userId="dd2ea628-74e6-45e1-a47e-522117d2ea3a" providerId="ADAL" clId="{C6C412C4-6624-4302-955C-D6C081F0BD65}" dt="2026-03-07T06:52:13.778" v="318" actId="1076"/>
          <ac:cxnSpMkLst>
            <pc:docMk/>
            <pc:sldMk cId="801831214" sldId="268"/>
            <ac:cxnSpMk id="88" creationId="{2757E3F3-A5B3-8291-2466-55BA258F7586}"/>
          </ac:cxnSpMkLst>
        </pc:cxnChg>
        <pc:cxnChg chg="add mod">
          <ac:chgData name="r15matsubara" userId="dd2ea628-74e6-45e1-a47e-522117d2ea3a" providerId="ADAL" clId="{C6C412C4-6624-4302-955C-D6C081F0BD65}" dt="2026-03-07T06:52:13.778" v="318" actId="1076"/>
          <ac:cxnSpMkLst>
            <pc:docMk/>
            <pc:sldMk cId="801831214" sldId="268"/>
            <ac:cxnSpMk id="89" creationId="{E0059880-2F5C-B803-9E72-6A052A056A0E}"/>
          </ac:cxnSpMkLst>
        </pc:cxnChg>
        <pc:cxnChg chg="add mod">
          <ac:chgData name="r15matsubara" userId="dd2ea628-74e6-45e1-a47e-522117d2ea3a" providerId="ADAL" clId="{C6C412C4-6624-4302-955C-D6C081F0BD65}" dt="2026-03-07T06:52:39.330" v="330" actId="1076"/>
          <ac:cxnSpMkLst>
            <pc:docMk/>
            <pc:sldMk cId="801831214" sldId="268"/>
            <ac:cxnSpMk id="91" creationId="{806BFD84-76EC-DF17-D63F-B129B24412DF}"/>
          </ac:cxnSpMkLst>
        </pc:cxnChg>
      </pc:sldChg>
      <pc:sldChg chg="addSp delSp modSp new mod">
        <pc:chgData name="r15matsubara" userId="dd2ea628-74e6-45e1-a47e-522117d2ea3a" providerId="ADAL" clId="{C6C412C4-6624-4302-955C-D6C081F0BD65}" dt="2026-03-09T09:41:23.220" v="795" actId="1037"/>
        <pc:sldMkLst>
          <pc:docMk/>
          <pc:sldMk cId="1868798255" sldId="269"/>
        </pc:sldMkLst>
        <pc:spChg chg="add mod">
          <ac:chgData name="r15matsubara" userId="dd2ea628-74e6-45e1-a47e-522117d2ea3a" providerId="ADAL" clId="{C6C412C4-6624-4302-955C-D6C081F0BD65}" dt="2026-03-07T07:03:00.861" v="418" actId="1076"/>
          <ac:spMkLst>
            <pc:docMk/>
            <pc:sldMk cId="1868798255" sldId="269"/>
            <ac:spMk id="11" creationId="{118C9D5A-0602-C6E3-1E35-E44FBF0F30F1}"/>
          </ac:spMkLst>
        </pc:spChg>
        <pc:spChg chg="add mod">
          <ac:chgData name="r15matsubara" userId="dd2ea628-74e6-45e1-a47e-522117d2ea3a" providerId="ADAL" clId="{C6C412C4-6624-4302-955C-D6C081F0BD65}" dt="2026-03-07T07:03:03.535" v="419" actId="1076"/>
          <ac:spMkLst>
            <pc:docMk/>
            <pc:sldMk cId="1868798255" sldId="269"/>
            <ac:spMk id="12" creationId="{E60AE867-740D-0CE1-71F5-D7E6B7933434}"/>
          </ac:spMkLst>
        </pc:spChg>
        <pc:spChg chg="add mod">
          <ac:chgData name="r15matsubara" userId="dd2ea628-74e6-45e1-a47e-522117d2ea3a" providerId="ADAL" clId="{C6C412C4-6624-4302-955C-D6C081F0BD65}" dt="2026-03-07T07:03:16.392" v="421" actId="1076"/>
          <ac:spMkLst>
            <pc:docMk/>
            <pc:sldMk cId="1868798255" sldId="269"/>
            <ac:spMk id="13" creationId="{18E04DF7-3DED-139E-B2D9-573420A7DF80}"/>
          </ac:spMkLst>
        </pc:spChg>
        <pc:spChg chg="add mod">
          <ac:chgData name="r15matsubara" userId="dd2ea628-74e6-45e1-a47e-522117d2ea3a" providerId="ADAL" clId="{C6C412C4-6624-4302-955C-D6C081F0BD65}" dt="2026-03-07T07:03:16.392" v="421" actId="1076"/>
          <ac:spMkLst>
            <pc:docMk/>
            <pc:sldMk cId="1868798255" sldId="269"/>
            <ac:spMk id="14" creationId="{A5094617-E787-DFA6-AFD8-C309F1ABBE48}"/>
          </ac:spMkLst>
        </pc:spChg>
        <pc:spChg chg="add mod">
          <ac:chgData name="r15matsubara" userId="dd2ea628-74e6-45e1-a47e-522117d2ea3a" providerId="ADAL" clId="{C6C412C4-6624-4302-955C-D6C081F0BD65}" dt="2026-03-07T07:03:16.392" v="421" actId="1076"/>
          <ac:spMkLst>
            <pc:docMk/>
            <pc:sldMk cId="1868798255" sldId="269"/>
            <ac:spMk id="15" creationId="{0FCFC774-43C8-260B-A521-8613817E468E}"/>
          </ac:spMkLst>
        </pc:spChg>
        <pc:spChg chg="add mod">
          <ac:chgData name="r15matsubara" userId="dd2ea628-74e6-45e1-a47e-522117d2ea3a" providerId="ADAL" clId="{C6C412C4-6624-4302-955C-D6C081F0BD65}" dt="2026-03-07T07:03:16.392" v="421" actId="1076"/>
          <ac:spMkLst>
            <pc:docMk/>
            <pc:sldMk cId="1868798255" sldId="269"/>
            <ac:spMk id="16" creationId="{A0FF51BF-78FC-F646-F799-B02F5A78C1A8}"/>
          </ac:spMkLst>
        </pc:spChg>
        <pc:spChg chg="add mod">
          <ac:chgData name="r15matsubara" userId="dd2ea628-74e6-45e1-a47e-522117d2ea3a" providerId="ADAL" clId="{C6C412C4-6624-4302-955C-D6C081F0BD65}" dt="2026-03-07T07:03:16.392" v="421" actId="1076"/>
          <ac:spMkLst>
            <pc:docMk/>
            <pc:sldMk cId="1868798255" sldId="269"/>
            <ac:spMk id="17" creationId="{AF929D75-1948-8596-D6BA-07C3A1BE2116}"/>
          </ac:spMkLst>
        </pc:spChg>
        <pc:spChg chg="add mod">
          <ac:chgData name="r15matsubara" userId="dd2ea628-74e6-45e1-a47e-522117d2ea3a" providerId="ADAL" clId="{C6C412C4-6624-4302-955C-D6C081F0BD65}" dt="2026-03-07T07:03:16.392" v="421" actId="1076"/>
          <ac:spMkLst>
            <pc:docMk/>
            <pc:sldMk cId="1868798255" sldId="269"/>
            <ac:spMk id="18" creationId="{9D00ADB9-9AA5-FC3B-6689-4243FE0EBAC3}"/>
          </ac:spMkLst>
        </pc:spChg>
        <pc:spChg chg="add mod">
          <ac:chgData name="r15matsubara" userId="dd2ea628-74e6-45e1-a47e-522117d2ea3a" providerId="ADAL" clId="{C6C412C4-6624-4302-955C-D6C081F0BD65}" dt="2026-03-07T07:03:16.392" v="421" actId="1076"/>
          <ac:spMkLst>
            <pc:docMk/>
            <pc:sldMk cId="1868798255" sldId="269"/>
            <ac:spMk id="19" creationId="{BB96EFA4-241B-A5A7-379B-DAAC42EF486D}"/>
          </ac:spMkLst>
        </pc:spChg>
        <pc:spChg chg="add mod">
          <ac:chgData name="r15matsubara" userId="dd2ea628-74e6-45e1-a47e-522117d2ea3a" providerId="ADAL" clId="{C6C412C4-6624-4302-955C-D6C081F0BD65}" dt="2026-03-07T07:04:45.748" v="482" actId="20577"/>
          <ac:spMkLst>
            <pc:docMk/>
            <pc:sldMk cId="1868798255" sldId="269"/>
            <ac:spMk id="20" creationId="{A0D1DCB7-AB05-592A-0F3D-0555FE08F729}"/>
          </ac:spMkLst>
        </pc:spChg>
        <pc:spChg chg="add mod">
          <ac:chgData name="r15matsubara" userId="dd2ea628-74e6-45e1-a47e-522117d2ea3a" providerId="ADAL" clId="{C6C412C4-6624-4302-955C-D6C081F0BD65}" dt="2026-03-07T07:04:05.968" v="465" actId="1038"/>
          <ac:spMkLst>
            <pc:docMk/>
            <pc:sldMk cId="1868798255" sldId="269"/>
            <ac:spMk id="21" creationId="{90F499E8-8AAB-28A8-B337-B87C92D0527E}"/>
          </ac:spMkLst>
        </pc:spChg>
        <pc:spChg chg="add mod">
          <ac:chgData name="r15matsubara" userId="dd2ea628-74e6-45e1-a47e-522117d2ea3a" providerId="ADAL" clId="{C6C412C4-6624-4302-955C-D6C081F0BD65}" dt="2026-03-07T07:03:55.645" v="439" actId="1038"/>
          <ac:spMkLst>
            <pc:docMk/>
            <pc:sldMk cId="1868798255" sldId="269"/>
            <ac:spMk id="22" creationId="{4B5C737A-9CA5-1CB7-6992-503647A65533}"/>
          </ac:spMkLst>
        </pc:spChg>
        <pc:spChg chg="add mod">
          <ac:chgData name="r15matsubara" userId="dd2ea628-74e6-45e1-a47e-522117d2ea3a" providerId="ADAL" clId="{C6C412C4-6624-4302-955C-D6C081F0BD65}" dt="2026-03-07T07:03:40.273" v="423" actId="1076"/>
          <ac:spMkLst>
            <pc:docMk/>
            <pc:sldMk cId="1868798255" sldId="269"/>
            <ac:spMk id="23" creationId="{EF5DD16C-E9CF-B8B4-97C2-65ECF3BF2439}"/>
          </ac:spMkLst>
        </pc:spChg>
        <pc:spChg chg="add mod">
          <ac:chgData name="r15matsubara" userId="dd2ea628-74e6-45e1-a47e-522117d2ea3a" providerId="ADAL" clId="{C6C412C4-6624-4302-955C-D6C081F0BD65}" dt="2026-03-07T07:03:40.273" v="423" actId="1076"/>
          <ac:spMkLst>
            <pc:docMk/>
            <pc:sldMk cId="1868798255" sldId="269"/>
            <ac:spMk id="24" creationId="{AA40B4D3-65AB-3F58-BB5E-BA7E38AA68ED}"/>
          </ac:spMkLst>
        </pc:spChg>
        <pc:spChg chg="add mod">
          <ac:chgData name="r15matsubara" userId="dd2ea628-74e6-45e1-a47e-522117d2ea3a" providerId="ADAL" clId="{C6C412C4-6624-4302-955C-D6C081F0BD65}" dt="2026-03-07T07:03:40.273" v="423" actId="1076"/>
          <ac:spMkLst>
            <pc:docMk/>
            <pc:sldMk cId="1868798255" sldId="269"/>
            <ac:spMk id="25" creationId="{50941B2D-DB6E-B8D5-81B6-990F3F7C8A36}"/>
          </ac:spMkLst>
        </pc:spChg>
        <pc:spChg chg="add mod">
          <ac:chgData name="r15matsubara" userId="dd2ea628-74e6-45e1-a47e-522117d2ea3a" providerId="ADAL" clId="{C6C412C4-6624-4302-955C-D6C081F0BD65}" dt="2026-03-07T07:04:03.637" v="461" actId="1038"/>
          <ac:spMkLst>
            <pc:docMk/>
            <pc:sldMk cId="1868798255" sldId="269"/>
            <ac:spMk id="28" creationId="{9BF84D7B-54A8-FDAB-E846-C8F57F8CEE2C}"/>
          </ac:spMkLst>
        </pc:spChg>
        <pc:spChg chg="add mod">
          <ac:chgData name="r15matsubara" userId="dd2ea628-74e6-45e1-a47e-522117d2ea3a" providerId="ADAL" clId="{C6C412C4-6624-4302-955C-D6C081F0BD65}" dt="2026-03-09T09:40:51.209" v="778" actId="1037"/>
          <ac:spMkLst>
            <pc:docMk/>
            <pc:sldMk cId="1868798255" sldId="269"/>
            <ac:spMk id="35" creationId="{18FE683F-0335-CDB5-2BCD-35A0B1703769}"/>
          </ac:spMkLst>
        </pc:spChg>
        <pc:spChg chg="add mod">
          <ac:chgData name="r15matsubara" userId="dd2ea628-74e6-45e1-a47e-522117d2ea3a" providerId="ADAL" clId="{C6C412C4-6624-4302-955C-D6C081F0BD65}" dt="2026-03-09T09:40:51.209" v="778" actId="1037"/>
          <ac:spMkLst>
            <pc:docMk/>
            <pc:sldMk cId="1868798255" sldId="269"/>
            <ac:spMk id="36" creationId="{F591F081-1886-F8A9-EB1F-AA92E686CF95}"/>
          </ac:spMkLst>
        </pc:spChg>
        <pc:spChg chg="add mod">
          <ac:chgData name="r15matsubara" userId="dd2ea628-74e6-45e1-a47e-522117d2ea3a" providerId="ADAL" clId="{C6C412C4-6624-4302-955C-D6C081F0BD65}" dt="2026-03-09T09:40:51.209" v="778" actId="1037"/>
          <ac:spMkLst>
            <pc:docMk/>
            <pc:sldMk cId="1868798255" sldId="269"/>
            <ac:spMk id="37" creationId="{5E6D8487-4A2C-5906-F2E0-ACE1F151FCF9}"/>
          </ac:spMkLst>
        </pc:spChg>
        <pc:spChg chg="add mod">
          <ac:chgData name="r15matsubara" userId="dd2ea628-74e6-45e1-a47e-522117d2ea3a" providerId="ADAL" clId="{C6C412C4-6624-4302-955C-D6C081F0BD65}" dt="2026-03-09T09:40:51.209" v="778" actId="1037"/>
          <ac:spMkLst>
            <pc:docMk/>
            <pc:sldMk cId="1868798255" sldId="269"/>
            <ac:spMk id="38" creationId="{F2EEE64C-8B57-C1D9-EB94-3EC2E94BA4AA}"/>
          </ac:spMkLst>
        </pc:spChg>
        <pc:spChg chg="add mod">
          <ac:chgData name="r15matsubara" userId="dd2ea628-74e6-45e1-a47e-522117d2ea3a" providerId="ADAL" clId="{C6C412C4-6624-4302-955C-D6C081F0BD65}" dt="2026-03-09T09:40:51.209" v="778" actId="1037"/>
          <ac:spMkLst>
            <pc:docMk/>
            <pc:sldMk cId="1868798255" sldId="269"/>
            <ac:spMk id="39" creationId="{72C49AD0-BF75-B69E-BA8C-52C37FC14FE6}"/>
          </ac:spMkLst>
        </pc:spChg>
        <pc:spChg chg="add mod">
          <ac:chgData name="r15matsubara" userId="dd2ea628-74e6-45e1-a47e-522117d2ea3a" providerId="ADAL" clId="{C6C412C4-6624-4302-955C-D6C081F0BD65}" dt="2026-03-09T09:40:51.209" v="778" actId="1037"/>
          <ac:spMkLst>
            <pc:docMk/>
            <pc:sldMk cId="1868798255" sldId="269"/>
            <ac:spMk id="40" creationId="{4AD8B81D-3E3D-631C-B008-2299C07C6E32}"/>
          </ac:spMkLst>
        </pc:spChg>
        <pc:spChg chg="add mod">
          <ac:chgData name="r15matsubara" userId="dd2ea628-74e6-45e1-a47e-522117d2ea3a" providerId="ADAL" clId="{C6C412C4-6624-4302-955C-D6C081F0BD65}" dt="2026-03-09T09:40:51.209" v="778" actId="1037"/>
          <ac:spMkLst>
            <pc:docMk/>
            <pc:sldMk cId="1868798255" sldId="269"/>
            <ac:spMk id="41" creationId="{8119D0B5-4D6C-D56E-0976-45D12D23F77A}"/>
          </ac:spMkLst>
        </pc:spChg>
        <pc:spChg chg="add del mod">
          <ac:chgData name="r15matsubara" userId="dd2ea628-74e6-45e1-a47e-522117d2ea3a" providerId="ADAL" clId="{C6C412C4-6624-4302-955C-D6C081F0BD65}" dt="2026-03-09T09:38:09.570" v="718" actId="478"/>
          <ac:spMkLst>
            <pc:docMk/>
            <pc:sldMk cId="1868798255" sldId="269"/>
            <ac:spMk id="42" creationId="{2D1A1EC7-AF16-729B-C897-0CFBFA936DFD}"/>
          </ac:spMkLst>
        </pc:spChg>
        <pc:spChg chg="add del mod">
          <ac:chgData name="r15matsubara" userId="dd2ea628-74e6-45e1-a47e-522117d2ea3a" providerId="ADAL" clId="{C6C412C4-6624-4302-955C-D6C081F0BD65}" dt="2026-03-09T09:39:42.221" v="735" actId="478"/>
          <ac:spMkLst>
            <pc:docMk/>
            <pc:sldMk cId="1868798255" sldId="269"/>
            <ac:spMk id="43" creationId="{D73DECEB-AB5C-A820-2468-E97D91534AE8}"/>
          </ac:spMkLst>
        </pc:spChg>
        <pc:spChg chg="add mod">
          <ac:chgData name="r15matsubara" userId="dd2ea628-74e6-45e1-a47e-522117d2ea3a" providerId="ADAL" clId="{C6C412C4-6624-4302-955C-D6C081F0BD65}" dt="2026-03-09T09:41:05.268" v="779" actId="1076"/>
          <ac:spMkLst>
            <pc:docMk/>
            <pc:sldMk cId="1868798255" sldId="269"/>
            <ac:spMk id="44" creationId="{600C8C11-0035-38D1-BB38-6DD662CF0316}"/>
          </ac:spMkLst>
        </pc:spChg>
        <pc:spChg chg="add mod">
          <ac:chgData name="r15matsubara" userId="dd2ea628-74e6-45e1-a47e-522117d2ea3a" providerId="ADAL" clId="{C6C412C4-6624-4302-955C-D6C081F0BD65}" dt="2026-03-09T09:41:23.220" v="795" actId="1037"/>
          <ac:spMkLst>
            <pc:docMk/>
            <pc:sldMk cId="1868798255" sldId="269"/>
            <ac:spMk id="45" creationId="{E2C4FEAD-F563-9D62-8127-6BC6EA8ED9FF}"/>
          </ac:spMkLst>
        </pc:spChg>
        <pc:spChg chg="add mod">
          <ac:chgData name="r15matsubara" userId="dd2ea628-74e6-45e1-a47e-522117d2ea3a" providerId="ADAL" clId="{C6C412C4-6624-4302-955C-D6C081F0BD65}" dt="2026-03-09T09:41:05.268" v="779" actId="1076"/>
          <ac:spMkLst>
            <pc:docMk/>
            <pc:sldMk cId="1868798255" sldId="269"/>
            <ac:spMk id="46" creationId="{874BAEA2-7D06-9BF6-5B48-86B08ED822A5}"/>
          </ac:spMkLst>
        </pc:spChg>
        <pc:spChg chg="add mod">
          <ac:chgData name="r15matsubara" userId="dd2ea628-74e6-45e1-a47e-522117d2ea3a" providerId="ADAL" clId="{C6C412C4-6624-4302-955C-D6C081F0BD65}" dt="2026-03-09T09:41:05.268" v="779" actId="1076"/>
          <ac:spMkLst>
            <pc:docMk/>
            <pc:sldMk cId="1868798255" sldId="269"/>
            <ac:spMk id="47" creationId="{DADA0440-416C-1CA2-4287-382F8FDC08D9}"/>
          </ac:spMkLst>
        </pc:spChg>
        <pc:spChg chg="add mod">
          <ac:chgData name="r15matsubara" userId="dd2ea628-74e6-45e1-a47e-522117d2ea3a" providerId="ADAL" clId="{C6C412C4-6624-4302-955C-D6C081F0BD65}" dt="2026-03-09T09:41:23.220" v="795" actId="1037"/>
          <ac:spMkLst>
            <pc:docMk/>
            <pc:sldMk cId="1868798255" sldId="269"/>
            <ac:spMk id="48" creationId="{30B57598-26B8-C241-AAE8-75FA26A16B2F}"/>
          </ac:spMkLst>
        </pc:spChg>
        <pc:spChg chg="add mod">
          <ac:chgData name="r15matsubara" userId="dd2ea628-74e6-45e1-a47e-522117d2ea3a" providerId="ADAL" clId="{C6C412C4-6624-4302-955C-D6C081F0BD65}" dt="2026-03-09T09:41:09.424" v="780" actId="1076"/>
          <ac:spMkLst>
            <pc:docMk/>
            <pc:sldMk cId="1868798255" sldId="269"/>
            <ac:spMk id="49" creationId="{4051D293-2A29-92F6-2636-B1827E3CE40F}"/>
          </ac:spMkLst>
        </pc:spChg>
        <pc:spChg chg="add mod">
          <ac:chgData name="r15matsubara" userId="dd2ea628-74e6-45e1-a47e-522117d2ea3a" providerId="ADAL" clId="{C6C412C4-6624-4302-955C-D6C081F0BD65}" dt="2026-03-09T09:41:23.220" v="795" actId="1037"/>
          <ac:spMkLst>
            <pc:docMk/>
            <pc:sldMk cId="1868798255" sldId="269"/>
            <ac:spMk id="52" creationId="{99ECC20F-BC1B-FEE7-88F3-E26BB4305FD2}"/>
          </ac:spMkLst>
        </pc:spChg>
        <pc:spChg chg="add mod">
          <ac:chgData name="r15matsubara" userId="dd2ea628-74e6-45e1-a47e-522117d2ea3a" providerId="ADAL" clId="{C6C412C4-6624-4302-955C-D6C081F0BD65}" dt="2026-03-07T07:18:46.932" v="604" actId="20577"/>
          <ac:spMkLst>
            <pc:docMk/>
            <pc:sldMk cId="1868798255" sldId="269"/>
            <ac:spMk id="53" creationId="{8511AD1C-75A7-B275-1850-22A5B25B79A7}"/>
          </ac:spMkLst>
        </pc:spChg>
        <pc:spChg chg="add mod">
          <ac:chgData name="r15matsubara" userId="dd2ea628-74e6-45e1-a47e-522117d2ea3a" providerId="ADAL" clId="{C6C412C4-6624-4302-955C-D6C081F0BD65}" dt="2026-03-07T07:18:21.060" v="598" actId="1076"/>
          <ac:spMkLst>
            <pc:docMk/>
            <pc:sldMk cId="1868798255" sldId="269"/>
            <ac:spMk id="54" creationId="{1AB13788-4A19-7CA5-FC13-1E4CFEC9C391}"/>
          </ac:spMkLst>
        </pc:spChg>
        <pc:picChg chg="add mod ord modCrop">
          <ac:chgData name="r15matsubara" userId="dd2ea628-74e6-45e1-a47e-522117d2ea3a" providerId="ADAL" clId="{C6C412C4-6624-4302-955C-D6C081F0BD65}" dt="2026-03-09T09:39:59.330" v="742" actId="167"/>
          <ac:picMkLst>
            <pc:docMk/>
            <pc:sldMk cId="1868798255" sldId="269"/>
            <ac:picMk id="3" creationId="{8F50E614-0ACC-66FF-315D-87B42A539EA2}"/>
          </ac:picMkLst>
        </pc:picChg>
        <pc:picChg chg="add mod modCrop">
          <ac:chgData name="r15matsubara" userId="dd2ea628-74e6-45e1-a47e-522117d2ea3a" providerId="ADAL" clId="{C6C412C4-6624-4302-955C-D6C081F0BD65}" dt="2026-03-07T07:02:10.761" v="404" actId="208"/>
          <ac:picMkLst>
            <pc:docMk/>
            <pc:sldMk cId="1868798255" sldId="269"/>
            <ac:picMk id="5" creationId="{DBFFC4A1-F5E6-63C5-4B81-E7894FA47DBF}"/>
          </ac:picMkLst>
        </pc:picChg>
        <pc:picChg chg="add mod ord modCrop">
          <ac:chgData name="r15matsubara" userId="dd2ea628-74e6-45e1-a47e-522117d2ea3a" providerId="ADAL" clId="{C6C412C4-6624-4302-955C-D6C081F0BD65}" dt="2026-03-09T09:39:59.330" v="742" actId="167"/>
          <ac:picMkLst>
            <pc:docMk/>
            <pc:sldMk cId="1868798255" sldId="269"/>
            <ac:picMk id="6" creationId="{6EC0A445-409A-01A4-D558-113D185222D0}"/>
          </ac:picMkLst>
        </pc:picChg>
        <pc:picChg chg="add mod modCrop">
          <ac:chgData name="r15matsubara" userId="dd2ea628-74e6-45e1-a47e-522117d2ea3a" providerId="ADAL" clId="{C6C412C4-6624-4302-955C-D6C081F0BD65}" dt="2026-03-07T07:02:49.749" v="415" actId="1076"/>
          <ac:picMkLst>
            <pc:docMk/>
            <pc:sldMk cId="1868798255" sldId="269"/>
            <ac:picMk id="7" creationId="{C6692BC3-F150-8277-3FA7-F318401FDD1D}"/>
          </ac:picMkLst>
        </pc:picChg>
        <pc:picChg chg="add mod modCrop">
          <ac:chgData name="r15matsubara" userId="dd2ea628-74e6-45e1-a47e-522117d2ea3a" providerId="ADAL" clId="{C6C412C4-6624-4302-955C-D6C081F0BD65}" dt="2026-03-07T07:02:52.382" v="416" actId="1076"/>
          <ac:picMkLst>
            <pc:docMk/>
            <pc:sldMk cId="1868798255" sldId="269"/>
            <ac:picMk id="9" creationId="{41247E70-3F99-FB2C-33F5-A18A8895E26B}"/>
          </ac:picMkLst>
        </pc:picChg>
        <pc:picChg chg="add del mod modCrop">
          <ac:chgData name="r15matsubara" userId="dd2ea628-74e6-45e1-a47e-522117d2ea3a" providerId="ADAL" clId="{C6C412C4-6624-4302-955C-D6C081F0BD65}" dt="2026-03-09T09:38:06.125" v="716" actId="478"/>
          <ac:picMkLst>
            <pc:docMk/>
            <pc:sldMk cId="1868798255" sldId="269"/>
            <ac:picMk id="30" creationId="{636B16BF-43BE-42C0-96EE-06B22AC683C7}"/>
          </ac:picMkLst>
        </pc:picChg>
        <pc:picChg chg="add del mod modCrop">
          <ac:chgData name="r15matsubara" userId="dd2ea628-74e6-45e1-a47e-522117d2ea3a" providerId="ADAL" clId="{C6C412C4-6624-4302-955C-D6C081F0BD65}" dt="2026-03-09T09:38:06.125" v="716" actId="478"/>
          <ac:picMkLst>
            <pc:docMk/>
            <pc:sldMk cId="1868798255" sldId="269"/>
            <ac:picMk id="32" creationId="{8CE944C1-348A-B785-53A2-5AF9E0BAC941}"/>
          </ac:picMkLst>
        </pc:picChg>
        <pc:picChg chg="add del mod modCrop">
          <ac:chgData name="r15matsubara" userId="dd2ea628-74e6-45e1-a47e-522117d2ea3a" providerId="ADAL" clId="{C6C412C4-6624-4302-955C-D6C081F0BD65}" dt="2026-03-09T09:38:07.965" v="717" actId="478"/>
          <ac:picMkLst>
            <pc:docMk/>
            <pc:sldMk cId="1868798255" sldId="269"/>
            <ac:picMk id="34" creationId="{62254176-E985-5AFE-E6FE-50A5CA992BE0}"/>
          </ac:picMkLst>
        </pc:picChg>
        <pc:cxnChg chg="add mod">
          <ac:chgData name="r15matsubara" userId="dd2ea628-74e6-45e1-a47e-522117d2ea3a" providerId="ADAL" clId="{C6C412C4-6624-4302-955C-D6C081F0BD65}" dt="2026-03-07T07:03:40.273" v="423" actId="1076"/>
          <ac:cxnSpMkLst>
            <pc:docMk/>
            <pc:sldMk cId="1868798255" sldId="269"/>
            <ac:cxnSpMk id="26" creationId="{9A77AFBC-A501-43E1-2BE0-19719EE1FCCC}"/>
          </ac:cxnSpMkLst>
        </pc:cxnChg>
        <pc:cxnChg chg="add mod">
          <ac:chgData name="r15matsubara" userId="dd2ea628-74e6-45e1-a47e-522117d2ea3a" providerId="ADAL" clId="{C6C412C4-6624-4302-955C-D6C081F0BD65}" dt="2026-03-07T07:03:40.273" v="423" actId="1076"/>
          <ac:cxnSpMkLst>
            <pc:docMk/>
            <pc:sldMk cId="1868798255" sldId="269"/>
            <ac:cxnSpMk id="27" creationId="{AC19DEA4-2E25-0757-05BD-1C55E093D739}"/>
          </ac:cxnSpMkLst>
        </pc:cxnChg>
        <pc:cxnChg chg="add mod">
          <ac:chgData name="r15matsubara" userId="dd2ea628-74e6-45e1-a47e-522117d2ea3a" providerId="ADAL" clId="{C6C412C4-6624-4302-955C-D6C081F0BD65}" dt="2026-03-09T09:41:23.220" v="795" actId="1037"/>
          <ac:cxnSpMkLst>
            <pc:docMk/>
            <pc:sldMk cId="1868798255" sldId="269"/>
            <ac:cxnSpMk id="50" creationId="{4453E0CF-18C2-4029-3765-9DD950745AB7}"/>
          </ac:cxnSpMkLst>
        </pc:cxnChg>
        <pc:cxnChg chg="add mod">
          <ac:chgData name="r15matsubara" userId="dd2ea628-74e6-45e1-a47e-522117d2ea3a" providerId="ADAL" clId="{C6C412C4-6624-4302-955C-D6C081F0BD65}" dt="2026-03-09T09:41:05.268" v="779" actId="1076"/>
          <ac:cxnSpMkLst>
            <pc:docMk/>
            <pc:sldMk cId="1868798255" sldId="269"/>
            <ac:cxnSpMk id="51" creationId="{3C448333-B6E0-FC4C-1F77-DD968811A659}"/>
          </ac:cxnSpMkLst>
        </pc:cxnChg>
        <pc:cxnChg chg="add mod">
          <ac:chgData name="r15matsubara" userId="dd2ea628-74e6-45e1-a47e-522117d2ea3a" providerId="ADAL" clId="{C6C412C4-6624-4302-955C-D6C081F0BD65}" dt="2026-03-07T07:18:28.686" v="600" actId="1076"/>
          <ac:cxnSpMkLst>
            <pc:docMk/>
            <pc:sldMk cId="1868798255" sldId="269"/>
            <ac:cxnSpMk id="55" creationId="{635ADA9D-3BC1-F8DC-BAD5-1567B126C08F}"/>
          </ac:cxnSpMkLst>
        </pc:cxnChg>
        <pc:cxnChg chg="add mod">
          <ac:chgData name="r15matsubara" userId="dd2ea628-74e6-45e1-a47e-522117d2ea3a" providerId="ADAL" clId="{C6C412C4-6624-4302-955C-D6C081F0BD65}" dt="2026-03-07T07:18:34.319" v="602" actId="1076"/>
          <ac:cxnSpMkLst>
            <pc:docMk/>
            <pc:sldMk cId="1868798255" sldId="269"/>
            <ac:cxnSpMk id="56" creationId="{AFBA9792-1935-95AD-D9A0-27AC2DC1D9D4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25574-99BC-4DA9-8C3B-1D78B4EC2749}" type="datetimeFigureOut">
              <a:rPr kumimoji="1" lang="ja-JP" altLang="en-US" smtClean="0"/>
              <a:t>2026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32EC9-EB4D-4E2C-9C01-2DE03DB920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3650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25574-99BC-4DA9-8C3B-1D78B4EC2749}" type="datetimeFigureOut">
              <a:rPr kumimoji="1" lang="ja-JP" altLang="en-US" smtClean="0"/>
              <a:t>2026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32EC9-EB4D-4E2C-9C01-2DE03DB920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1324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25574-99BC-4DA9-8C3B-1D78B4EC2749}" type="datetimeFigureOut">
              <a:rPr kumimoji="1" lang="ja-JP" altLang="en-US" smtClean="0"/>
              <a:t>2026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32EC9-EB4D-4E2C-9C01-2DE03DB920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5580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25574-99BC-4DA9-8C3B-1D78B4EC2749}" type="datetimeFigureOut">
              <a:rPr kumimoji="1" lang="ja-JP" altLang="en-US" smtClean="0"/>
              <a:t>2026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32EC9-EB4D-4E2C-9C01-2DE03DB920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44354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25574-99BC-4DA9-8C3B-1D78B4EC2749}" type="datetimeFigureOut">
              <a:rPr kumimoji="1" lang="ja-JP" altLang="en-US" smtClean="0"/>
              <a:t>2026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32EC9-EB4D-4E2C-9C01-2DE03DB920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91335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25574-99BC-4DA9-8C3B-1D78B4EC2749}" type="datetimeFigureOut">
              <a:rPr kumimoji="1" lang="ja-JP" altLang="en-US" smtClean="0"/>
              <a:t>2026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32EC9-EB4D-4E2C-9C01-2DE03DB920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50081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25574-99BC-4DA9-8C3B-1D78B4EC2749}" type="datetimeFigureOut">
              <a:rPr kumimoji="1" lang="ja-JP" altLang="en-US" smtClean="0"/>
              <a:t>2026/3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32EC9-EB4D-4E2C-9C01-2DE03DB920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301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25574-99BC-4DA9-8C3B-1D78B4EC2749}" type="datetimeFigureOut">
              <a:rPr kumimoji="1" lang="ja-JP" altLang="en-US" smtClean="0"/>
              <a:t>2026/3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32EC9-EB4D-4E2C-9C01-2DE03DB920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9001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25574-99BC-4DA9-8C3B-1D78B4EC2749}" type="datetimeFigureOut">
              <a:rPr kumimoji="1" lang="ja-JP" altLang="en-US" smtClean="0"/>
              <a:t>2026/3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32EC9-EB4D-4E2C-9C01-2DE03DB920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6681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25574-99BC-4DA9-8C3B-1D78B4EC2749}" type="datetimeFigureOut">
              <a:rPr kumimoji="1" lang="ja-JP" altLang="en-US" smtClean="0"/>
              <a:t>2026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32EC9-EB4D-4E2C-9C01-2DE03DB920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32513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25574-99BC-4DA9-8C3B-1D78B4EC2749}" type="datetimeFigureOut">
              <a:rPr kumimoji="1" lang="ja-JP" altLang="en-US" smtClean="0"/>
              <a:t>2026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32EC9-EB4D-4E2C-9C01-2DE03DB920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61295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725574-99BC-4DA9-8C3B-1D78B4EC2749}" type="datetimeFigureOut">
              <a:rPr kumimoji="1" lang="ja-JP" altLang="en-US" smtClean="0"/>
              <a:t>2026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B32EC9-EB4D-4E2C-9C01-2DE03DB920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35411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ti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g"/><Relationship Id="rId3" Type="http://schemas.openxmlformats.org/officeDocument/2006/relationships/image" Target="../media/image10.jpg"/><Relationship Id="rId7" Type="http://schemas.openxmlformats.org/officeDocument/2006/relationships/image" Target="../media/image14.tif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g"/><Relationship Id="rId5" Type="http://schemas.openxmlformats.org/officeDocument/2006/relationships/image" Target="../media/image12.jpg"/><Relationship Id="rId4" Type="http://schemas.openxmlformats.org/officeDocument/2006/relationships/image" Target="../media/image11.jpg"/><Relationship Id="rId9" Type="http://schemas.openxmlformats.org/officeDocument/2006/relationships/image" Target="../media/image16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jpg"/><Relationship Id="rId5" Type="http://schemas.openxmlformats.org/officeDocument/2006/relationships/image" Target="../media/image20.jpg"/><Relationship Id="rId4" Type="http://schemas.openxmlformats.org/officeDocument/2006/relationships/image" Target="../media/image1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白黒の写真&#10;&#10;AI 生成コンテンツは誤りを含む可能性があります。">
            <a:extLst>
              <a:ext uri="{FF2B5EF4-FFF2-40B4-BE49-F238E27FC236}">
                <a16:creationId xmlns:a16="http://schemas.microsoft.com/office/drawing/2014/main" id="{65936D69-7A9E-211F-6239-CA858365776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49" t="7060" r="19301" b="7465"/>
          <a:stretch>
            <a:fillRect/>
          </a:stretch>
        </p:blipFill>
        <p:spPr>
          <a:xfrm>
            <a:off x="723899" y="803149"/>
            <a:ext cx="2236471" cy="2407631"/>
          </a:xfrm>
          <a:prstGeom prst="rect">
            <a:avLst/>
          </a:prstGeom>
        </p:spPr>
      </p:pic>
      <p:pic>
        <p:nvPicPr>
          <p:cNvPr id="5" name="図 4" descr="写真, 座る, 部屋, キッチン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223BB9C3-3008-584E-012C-7C36D49C6CB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89" t="9892" r="22222" b="11215"/>
          <a:stretch>
            <a:fillRect/>
          </a:stretch>
        </p:blipFill>
        <p:spPr>
          <a:xfrm>
            <a:off x="3097530" y="903174"/>
            <a:ext cx="2132350" cy="223646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19B76E5-2152-92CD-FA7A-2BCE22C3E3A7}"/>
              </a:ext>
            </a:extLst>
          </p:cNvPr>
          <p:cNvSpPr txBox="1"/>
          <p:nvPr/>
        </p:nvSpPr>
        <p:spPr>
          <a:xfrm>
            <a:off x="166428" y="1241820"/>
            <a:ext cx="5180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5ACB207-06FD-8B17-C3A9-CC6EDD258A0D}"/>
              </a:ext>
            </a:extLst>
          </p:cNvPr>
          <p:cNvSpPr txBox="1"/>
          <p:nvPr/>
        </p:nvSpPr>
        <p:spPr>
          <a:xfrm>
            <a:off x="166428" y="1415303"/>
            <a:ext cx="5180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4A226A3-2374-1DAC-82C9-32E642DDF49A}"/>
              </a:ext>
            </a:extLst>
          </p:cNvPr>
          <p:cNvSpPr txBox="1"/>
          <p:nvPr/>
        </p:nvSpPr>
        <p:spPr>
          <a:xfrm>
            <a:off x="216121" y="1528759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C296EAC-303B-9B7F-336E-EE0270FEEC79}"/>
              </a:ext>
            </a:extLst>
          </p:cNvPr>
          <p:cNvSpPr txBox="1"/>
          <p:nvPr/>
        </p:nvSpPr>
        <p:spPr>
          <a:xfrm>
            <a:off x="216121" y="1728814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0A8BCCB-2CAC-C6E6-855E-7082484B5784}"/>
              </a:ext>
            </a:extLst>
          </p:cNvPr>
          <p:cNvSpPr txBox="1"/>
          <p:nvPr/>
        </p:nvSpPr>
        <p:spPr>
          <a:xfrm>
            <a:off x="216121" y="1970915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94AA7D7-19A0-ADA0-72B8-9B0E1FEA7241}"/>
              </a:ext>
            </a:extLst>
          </p:cNvPr>
          <p:cNvSpPr txBox="1"/>
          <p:nvPr/>
        </p:nvSpPr>
        <p:spPr>
          <a:xfrm>
            <a:off x="166428" y="1115220"/>
            <a:ext cx="5180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824B2C5-9B39-1288-5781-9730D2766A31}"/>
              </a:ext>
            </a:extLst>
          </p:cNvPr>
          <p:cNvSpPr txBox="1"/>
          <p:nvPr/>
        </p:nvSpPr>
        <p:spPr>
          <a:xfrm>
            <a:off x="216121" y="2313043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3903E06-A616-ED04-486A-F5787C97F942}"/>
              </a:ext>
            </a:extLst>
          </p:cNvPr>
          <p:cNvSpPr txBox="1"/>
          <p:nvPr/>
        </p:nvSpPr>
        <p:spPr>
          <a:xfrm>
            <a:off x="216121" y="2513098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図 15" descr="水, 雪, 写真, 男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BF7A75BD-F2DB-E156-3F34-01D6CCFB693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11" t="14521" r="17389" b="4456"/>
          <a:stretch>
            <a:fillRect/>
          </a:stretch>
        </p:blipFill>
        <p:spPr>
          <a:xfrm>
            <a:off x="3296142" y="3990000"/>
            <a:ext cx="2004241" cy="23393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図 19" descr="写真, モニター, 座る, テーブル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967165AA-536E-F721-687D-910E8E76AC6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717" y="7240503"/>
            <a:ext cx="2487168" cy="1881051"/>
          </a:xfrm>
          <a:prstGeom prst="rect">
            <a:avLst/>
          </a:prstGeom>
        </p:spPr>
      </p:pic>
      <p:pic>
        <p:nvPicPr>
          <p:cNvPr id="22" name="図 21" descr="白い背景に黒い文字&#10;&#10;AI 生成コンテンツは誤りを含む可能性があります。">
            <a:extLst>
              <a:ext uri="{FF2B5EF4-FFF2-40B4-BE49-F238E27FC236}">
                <a16:creationId xmlns:a16="http://schemas.microsoft.com/office/drawing/2014/main" id="{7FCB1410-A207-66A4-D921-EBBE318031B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7620" y="7240503"/>
            <a:ext cx="2490499" cy="188105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08BC0FC-FD0C-1B51-45DE-5E7542CD1D5A}"/>
              </a:ext>
            </a:extLst>
          </p:cNvPr>
          <p:cNvSpPr txBox="1"/>
          <p:nvPr/>
        </p:nvSpPr>
        <p:spPr>
          <a:xfrm>
            <a:off x="1249680" y="464297"/>
            <a:ext cx="10390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62C2EAC-3092-6744-23A7-56486A47F20C}"/>
              </a:ext>
            </a:extLst>
          </p:cNvPr>
          <p:cNvSpPr txBox="1"/>
          <p:nvPr/>
        </p:nvSpPr>
        <p:spPr>
          <a:xfrm>
            <a:off x="3597804" y="274573"/>
            <a:ext cx="6552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ytosol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40053C3-3C92-AE74-77CC-A31ECD59038E}"/>
              </a:ext>
            </a:extLst>
          </p:cNvPr>
          <p:cNvSpPr txBox="1"/>
          <p:nvPr/>
        </p:nvSpPr>
        <p:spPr>
          <a:xfrm>
            <a:off x="4125049" y="274573"/>
            <a:ext cx="10120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ell membran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1A786F6-3158-8FE7-380A-99704863A508}"/>
              </a:ext>
            </a:extLst>
          </p:cNvPr>
          <p:cNvSpPr txBox="1"/>
          <p:nvPr/>
        </p:nvSpPr>
        <p:spPr>
          <a:xfrm>
            <a:off x="3676521" y="96305"/>
            <a:ext cx="7957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l-GR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tdTomato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958D85E-453D-08BB-03FF-24018ADC366F}"/>
              </a:ext>
            </a:extLst>
          </p:cNvPr>
          <p:cNvSpPr txBox="1"/>
          <p:nvPr/>
        </p:nvSpPr>
        <p:spPr>
          <a:xfrm rot="18775227">
            <a:off x="3505259" y="555690"/>
            <a:ext cx="6552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5B39530-2A69-2D8A-3994-FC795DF6FD36}"/>
              </a:ext>
            </a:extLst>
          </p:cNvPr>
          <p:cNvSpPr txBox="1"/>
          <p:nvPr/>
        </p:nvSpPr>
        <p:spPr>
          <a:xfrm rot="18775227">
            <a:off x="3752837" y="555690"/>
            <a:ext cx="5483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tress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線矢印コネクタ 33">
            <a:extLst>
              <a:ext uri="{FF2B5EF4-FFF2-40B4-BE49-F238E27FC236}">
                <a16:creationId xmlns:a16="http://schemas.microsoft.com/office/drawing/2014/main" id="{CF863594-9573-E732-56D8-BF4CE930528E}"/>
              </a:ext>
            </a:extLst>
          </p:cNvPr>
          <p:cNvCxnSpPr/>
          <p:nvPr/>
        </p:nvCxnSpPr>
        <p:spPr>
          <a:xfrm>
            <a:off x="3771028" y="824624"/>
            <a:ext cx="0" cy="1650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ADE7E9BD-9394-10D6-B54D-177959844036}"/>
              </a:ext>
            </a:extLst>
          </p:cNvPr>
          <p:cNvCxnSpPr/>
          <p:nvPr/>
        </p:nvCxnSpPr>
        <p:spPr>
          <a:xfrm>
            <a:off x="3958988" y="824624"/>
            <a:ext cx="0" cy="1650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844C7F72-85FA-2270-92B7-B58B23DD8F8C}"/>
              </a:ext>
            </a:extLst>
          </p:cNvPr>
          <p:cNvSpPr txBox="1"/>
          <p:nvPr/>
        </p:nvSpPr>
        <p:spPr>
          <a:xfrm rot="18775227">
            <a:off x="4059866" y="562618"/>
            <a:ext cx="6552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9FE3A5FA-626B-C027-8E2D-6448FE77EE51}"/>
              </a:ext>
            </a:extLst>
          </p:cNvPr>
          <p:cNvSpPr txBox="1"/>
          <p:nvPr/>
        </p:nvSpPr>
        <p:spPr>
          <a:xfrm rot="18775227">
            <a:off x="4307444" y="562618"/>
            <a:ext cx="5483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tress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線矢印コネクタ 37">
            <a:extLst>
              <a:ext uri="{FF2B5EF4-FFF2-40B4-BE49-F238E27FC236}">
                <a16:creationId xmlns:a16="http://schemas.microsoft.com/office/drawing/2014/main" id="{E87703DB-60AF-57C2-9417-96AC8C5640E8}"/>
              </a:ext>
            </a:extLst>
          </p:cNvPr>
          <p:cNvCxnSpPr/>
          <p:nvPr/>
        </p:nvCxnSpPr>
        <p:spPr>
          <a:xfrm>
            <a:off x="4325635" y="831552"/>
            <a:ext cx="0" cy="1650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矢印コネクタ 38">
            <a:extLst>
              <a:ext uri="{FF2B5EF4-FFF2-40B4-BE49-F238E27FC236}">
                <a16:creationId xmlns:a16="http://schemas.microsoft.com/office/drawing/2014/main" id="{A370F5CF-C2F6-7E34-9F42-386006B89BC4}"/>
              </a:ext>
            </a:extLst>
          </p:cNvPr>
          <p:cNvCxnSpPr/>
          <p:nvPr/>
        </p:nvCxnSpPr>
        <p:spPr>
          <a:xfrm>
            <a:off x="4513595" y="831552"/>
            <a:ext cx="0" cy="1650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2734A965-F3CC-72E0-7BBB-43CAC5D74B85}"/>
              </a:ext>
            </a:extLst>
          </p:cNvPr>
          <p:cNvCxnSpPr>
            <a:cxnSpLocks/>
          </p:cNvCxnSpPr>
          <p:nvPr/>
        </p:nvCxnSpPr>
        <p:spPr>
          <a:xfrm>
            <a:off x="3771028" y="499747"/>
            <a:ext cx="27732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ABA6D68F-D5F9-B5EB-2028-CCB216D29BA2}"/>
              </a:ext>
            </a:extLst>
          </p:cNvPr>
          <p:cNvCxnSpPr>
            <a:cxnSpLocks/>
          </p:cNvCxnSpPr>
          <p:nvPr/>
        </p:nvCxnSpPr>
        <p:spPr>
          <a:xfrm>
            <a:off x="4333654" y="499747"/>
            <a:ext cx="27732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1DC38F87-5035-01B1-35D9-8E4DD2663852}"/>
              </a:ext>
            </a:extLst>
          </p:cNvPr>
          <p:cNvCxnSpPr>
            <a:cxnSpLocks/>
          </p:cNvCxnSpPr>
          <p:nvPr/>
        </p:nvCxnSpPr>
        <p:spPr>
          <a:xfrm flipH="1">
            <a:off x="5137061" y="1615358"/>
            <a:ext cx="500365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8773A629-2BD9-C291-8AC2-308A26232670}"/>
              </a:ext>
            </a:extLst>
          </p:cNvPr>
          <p:cNvSpPr txBox="1"/>
          <p:nvPr/>
        </p:nvSpPr>
        <p:spPr>
          <a:xfrm>
            <a:off x="3711324" y="3411823"/>
            <a:ext cx="6552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ytosol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2C2AB09B-5C4B-36DB-2E46-ED11DBFD21DB}"/>
              </a:ext>
            </a:extLst>
          </p:cNvPr>
          <p:cNvSpPr txBox="1"/>
          <p:nvPr/>
        </p:nvSpPr>
        <p:spPr>
          <a:xfrm>
            <a:off x="4238569" y="3411823"/>
            <a:ext cx="10120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ell membran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87843C21-8CB4-99C9-2210-223E87F6E007}"/>
              </a:ext>
            </a:extLst>
          </p:cNvPr>
          <p:cNvSpPr txBox="1"/>
          <p:nvPr/>
        </p:nvSpPr>
        <p:spPr>
          <a:xfrm rot="18775227">
            <a:off x="3618779" y="3692940"/>
            <a:ext cx="6552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479D2324-D233-20B2-CE5E-57EAFA7DCBF4}"/>
              </a:ext>
            </a:extLst>
          </p:cNvPr>
          <p:cNvSpPr txBox="1"/>
          <p:nvPr/>
        </p:nvSpPr>
        <p:spPr>
          <a:xfrm rot="18775227">
            <a:off x="3866357" y="3692940"/>
            <a:ext cx="5483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tress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線矢印コネクタ 52">
            <a:extLst>
              <a:ext uri="{FF2B5EF4-FFF2-40B4-BE49-F238E27FC236}">
                <a16:creationId xmlns:a16="http://schemas.microsoft.com/office/drawing/2014/main" id="{4F2A6219-5CB9-24D2-F046-072F33B20C7B}"/>
              </a:ext>
            </a:extLst>
          </p:cNvPr>
          <p:cNvCxnSpPr/>
          <p:nvPr/>
        </p:nvCxnSpPr>
        <p:spPr>
          <a:xfrm>
            <a:off x="3884548" y="3961874"/>
            <a:ext cx="0" cy="1650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矢印コネクタ 53">
            <a:extLst>
              <a:ext uri="{FF2B5EF4-FFF2-40B4-BE49-F238E27FC236}">
                <a16:creationId xmlns:a16="http://schemas.microsoft.com/office/drawing/2014/main" id="{AC1288B9-8946-78C6-9E78-AB21030254C7}"/>
              </a:ext>
            </a:extLst>
          </p:cNvPr>
          <p:cNvCxnSpPr/>
          <p:nvPr/>
        </p:nvCxnSpPr>
        <p:spPr>
          <a:xfrm>
            <a:off x="4072508" y="3961874"/>
            <a:ext cx="0" cy="1650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EFA33EAE-2B67-1263-D1AA-96A38DFF901A}"/>
              </a:ext>
            </a:extLst>
          </p:cNvPr>
          <p:cNvSpPr txBox="1"/>
          <p:nvPr/>
        </p:nvSpPr>
        <p:spPr>
          <a:xfrm rot="18775227">
            <a:off x="4173386" y="3699868"/>
            <a:ext cx="6552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0516F7A-AAC6-0F8A-B92A-A03E1A0E1CE7}"/>
              </a:ext>
            </a:extLst>
          </p:cNvPr>
          <p:cNvSpPr txBox="1"/>
          <p:nvPr/>
        </p:nvSpPr>
        <p:spPr>
          <a:xfrm rot="18775227">
            <a:off x="4420964" y="3699868"/>
            <a:ext cx="5483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tress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直線矢印コネクタ 56">
            <a:extLst>
              <a:ext uri="{FF2B5EF4-FFF2-40B4-BE49-F238E27FC236}">
                <a16:creationId xmlns:a16="http://schemas.microsoft.com/office/drawing/2014/main" id="{FD9E398F-9033-B51E-DEEE-F1C7B94894F4}"/>
              </a:ext>
            </a:extLst>
          </p:cNvPr>
          <p:cNvCxnSpPr/>
          <p:nvPr/>
        </p:nvCxnSpPr>
        <p:spPr>
          <a:xfrm>
            <a:off x="4439155" y="3968802"/>
            <a:ext cx="0" cy="1650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矢印コネクタ 57">
            <a:extLst>
              <a:ext uri="{FF2B5EF4-FFF2-40B4-BE49-F238E27FC236}">
                <a16:creationId xmlns:a16="http://schemas.microsoft.com/office/drawing/2014/main" id="{CA462D79-AAE3-EF3E-A366-9904B495492B}"/>
              </a:ext>
            </a:extLst>
          </p:cNvPr>
          <p:cNvCxnSpPr/>
          <p:nvPr/>
        </p:nvCxnSpPr>
        <p:spPr>
          <a:xfrm>
            <a:off x="4627115" y="3968802"/>
            <a:ext cx="0" cy="1650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92B1A114-1993-C931-014B-8C8F292C7588}"/>
              </a:ext>
            </a:extLst>
          </p:cNvPr>
          <p:cNvCxnSpPr>
            <a:cxnSpLocks/>
          </p:cNvCxnSpPr>
          <p:nvPr/>
        </p:nvCxnSpPr>
        <p:spPr>
          <a:xfrm>
            <a:off x="3884548" y="3636997"/>
            <a:ext cx="27732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CB0808D7-F393-C4C4-C368-08FFC15E8494}"/>
              </a:ext>
            </a:extLst>
          </p:cNvPr>
          <p:cNvCxnSpPr>
            <a:cxnSpLocks/>
          </p:cNvCxnSpPr>
          <p:nvPr/>
        </p:nvCxnSpPr>
        <p:spPr>
          <a:xfrm>
            <a:off x="4447174" y="3636997"/>
            <a:ext cx="27732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3E22771-8685-6F2C-E12B-CF822E6C01B4}"/>
              </a:ext>
            </a:extLst>
          </p:cNvPr>
          <p:cNvSpPr txBox="1"/>
          <p:nvPr/>
        </p:nvSpPr>
        <p:spPr>
          <a:xfrm>
            <a:off x="3946425" y="3212917"/>
            <a:ext cx="7957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l-GR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Flotillin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直線矢印コネクタ 62">
            <a:extLst>
              <a:ext uri="{FF2B5EF4-FFF2-40B4-BE49-F238E27FC236}">
                <a16:creationId xmlns:a16="http://schemas.microsoft.com/office/drawing/2014/main" id="{6598775A-DD2E-46C0-FC47-29DDF33D6633}"/>
              </a:ext>
            </a:extLst>
          </p:cNvPr>
          <p:cNvCxnSpPr/>
          <p:nvPr/>
        </p:nvCxnSpPr>
        <p:spPr>
          <a:xfrm>
            <a:off x="3210560" y="3284220"/>
            <a:ext cx="0" cy="53106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8A22325A-0E11-A680-1C3A-4195EC8C5047}"/>
              </a:ext>
            </a:extLst>
          </p:cNvPr>
          <p:cNvSpPr txBox="1"/>
          <p:nvPr/>
        </p:nvSpPr>
        <p:spPr>
          <a:xfrm>
            <a:off x="2223389" y="3395544"/>
            <a:ext cx="9509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Re-blot</a:t>
            </a:r>
          </a:p>
          <a:p>
            <a:r>
              <a:rPr kumimoji="1" lang="en-US" altLang="ja-JP" sz="800" dirty="0"/>
              <a:t>(same membrane)</a:t>
            </a:r>
            <a:endParaRPr kumimoji="1" lang="ja-JP" altLang="en-US" sz="800" dirty="0"/>
          </a:p>
        </p:txBody>
      </p:sp>
      <p:cxnSp>
        <p:nvCxnSpPr>
          <p:cNvPr id="65" name="直線矢印コネクタ 64">
            <a:extLst>
              <a:ext uri="{FF2B5EF4-FFF2-40B4-BE49-F238E27FC236}">
                <a16:creationId xmlns:a16="http://schemas.microsoft.com/office/drawing/2014/main" id="{18D95762-9807-1586-270D-3C742810D8B3}"/>
              </a:ext>
            </a:extLst>
          </p:cNvPr>
          <p:cNvCxnSpPr>
            <a:cxnSpLocks/>
          </p:cNvCxnSpPr>
          <p:nvPr/>
        </p:nvCxnSpPr>
        <p:spPr>
          <a:xfrm flipH="1">
            <a:off x="5176858" y="5051978"/>
            <a:ext cx="500365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01905A06-03CA-ADE8-2F11-2D41CD7268F8}"/>
              </a:ext>
            </a:extLst>
          </p:cNvPr>
          <p:cNvSpPr txBox="1"/>
          <p:nvPr/>
        </p:nvSpPr>
        <p:spPr>
          <a:xfrm>
            <a:off x="4884034" y="6612793"/>
            <a:ext cx="6552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ytosol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D72DBD52-5088-9775-CDD3-C9B84383FE62}"/>
              </a:ext>
            </a:extLst>
          </p:cNvPr>
          <p:cNvSpPr txBox="1"/>
          <p:nvPr/>
        </p:nvSpPr>
        <p:spPr>
          <a:xfrm>
            <a:off x="5411279" y="6612793"/>
            <a:ext cx="10120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ell membran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5377CC44-A5FC-ED0C-391A-57BB015CE1DF}"/>
              </a:ext>
            </a:extLst>
          </p:cNvPr>
          <p:cNvSpPr txBox="1"/>
          <p:nvPr/>
        </p:nvSpPr>
        <p:spPr>
          <a:xfrm rot="18775227">
            <a:off x="4791489" y="6893910"/>
            <a:ext cx="6552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07F2BD91-0241-8F02-B004-A8FF3A8DE7F2}"/>
              </a:ext>
            </a:extLst>
          </p:cNvPr>
          <p:cNvSpPr txBox="1"/>
          <p:nvPr/>
        </p:nvSpPr>
        <p:spPr>
          <a:xfrm rot="18775227">
            <a:off x="5039067" y="6893910"/>
            <a:ext cx="5483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tress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直線矢印コネクタ 69">
            <a:extLst>
              <a:ext uri="{FF2B5EF4-FFF2-40B4-BE49-F238E27FC236}">
                <a16:creationId xmlns:a16="http://schemas.microsoft.com/office/drawing/2014/main" id="{2273BC73-D836-E97C-2BEF-5ACF594782E5}"/>
              </a:ext>
            </a:extLst>
          </p:cNvPr>
          <p:cNvCxnSpPr/>
          <p:nvPr/>
        </p:nvCxnSpPr>
        <p:spPr>
          <a:xfrm>
            <a:off x="5057258" y="7162844"/>
            <a:ext cx="0" cy="1650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矢印コネクタ 70">
            <a:extLst>
              <a:ext uri="{FF2B5EF4-FFF2-40B4-BE49-F238E27FC236}">
                <a16:creationId xmlns:a16="http://schemas.microsoft.com/office/drawing/2014/main" id="{69DEFF91-134F-F67C-E67F-2BAE7AEB03FD}"/>
              </a:ext>
            </a:extLst>
          </p:cNvPr>
          <p:cNvCxnSpPr/>
          <p:nvPr/>
        </p:nvCxnSpPr>
        <p:spPr>
          <a:xfrm>
            <a:off x="5245218" y="7162844"/>
            <a:ext cx="0" cy="1650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B4C1D1EC-F2B7-2F97-5FDE-384054C46E29}"/>
              </a:ext>
            </a:extLst>
          </p:cNvPr>
          <p:cNvSpPr txBox="1"/>
          <p:nvPr/>
        </p:nvSpPr>
        <p:spPr>
          <a:xfrm rot="18775227">
            <a:off x="5346096" y="6900838"/>
            <a:ext cx="6552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87909BF3-051D-E700-DD6C-D92A59CA1DB3}"/>
              </a:ext>
            </a:extLst>
          </p:cNvPr>
          <p:cNvSpPr txBox="1"/>
          <p:nvPr/>
        </p:nvSpPr>
        <p:spPr>
          <a:xfrm rot="18775227">
            <a:off x="5593674" y="6900838"/>
            <a:ext cx="5483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tress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直線矢印コネクタ 73">
            <a:extLst>
              <a:ext uri="{FF2B5EF4-FFF2-40B4-BE49-F238E27FC236}">
                <a16:creationId xmlns:a16="http://schemas.microsoft.com/office/drawing/2014/main" id="{9E470501-C9E4-AA79-7612-8C3B0CEA254B}"/>
              </a:ext>
            </a:extLst>
          </p:cNvPr>
          <p:cNvCxnSpPr/>
          <p:nvPr/>
        </p:nvCxnSpPr>
        <p:spPr>
          <a:xfrm>
            <a:off x="5611865" y="7169772"/>
            <a:ext cx="0" cy="1650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矢印コネクタ 74">
            <a:extLst>
              <a:ext uri="{FF2B5EF4-FFF2-40B4-BE49-F238E27FC236}">
                <a16:creationId xmlns:a16="http://schemas.microsoft.com/office/drawing/2014/main" id="{55D50D93-1F7E-92BE-D425-81046A268DE8}"/>
              </a:ext>
            </a:extLst>
          </p:cNvPr>
          <p:cNvCxnSpPr/>
          <p:nvPr/>
        </p:nvCxnSpPr>
        <p:spPr>
          <a:xfrm>
            <a:off x="5799825" y="7169772"/>
            <a:ext cx="0" cy="1650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864DA0ED-4F3C-B630-1FC5-E92F58E3FCE9}"/>
              </a:ext>
            </a:extLst>
          </p:cNvPr>
          <p:cNvCxnSpPr>
            <a:cxnSpLocks/>
          </p:cNvCxnSpPr>
          <p:nvPr/>
        </p:nvCxnSpPr>
        <p:spPr>
          <a:xfrm>
            <a:off x="5057258" y="6837967"/>
            <a:ext cx="27732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F6480486-3F04-E839-1271-375692B307F9}"/>
              </a:ext>
            </a:extLst>
          </p:cNvPr>
          <p:cNvCxnSpPr>
            <a:cxnSpLocks/>
          </p:cNvCxnSpPr>
          <p:nvPr/>
        </p:nvCxnSpPr>
        <p:spPr>
          <a:xfrm>
            <a:off x="5619884" y="6837967"/>
            <a:ext cx="27732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3E42023C-B048-4841-27C9-0844C141749B}"/>
              </a:ext>
            </a:extLst>
          </p:cNvPr>
          <p:cNvSpPr txBox="1"/>
          <p:nvPr/>
        </p:nvSpPr>
        <p:spPr>
          <a:xfrm>
            <a:off x="5119135" y="6413887"/>
            <a:ext cx="7957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l-GR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直線矢印コネクタ 78">
            <a:extLst>
              <a:ext uri="{FF2B5EF4-FFF2-40B4-BE49-F238E27FC236}">
                <a16:creationId xmlns:a16="http://schemas.microsoft.com/office/drawing/2014/main" id="{378B9F4A-EBAC-EB8B-8FD1-990170AC78A7}"/>
              </a:ext>
            </a:extLst>
          </p:cNvPr>
          <p:cNvCxnSpPr/>
          <p:nvPr/>
        </p:nvCxnSpPr>
        <p:spPr>
          <a:xfrm>
            <a:off x="4383270" y="6485190"/>
            <a:ext cx="0" cy="53106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58FCAE71-C73A-E593-9DA5-7961B8D1B728}"/>
              </a:ext>
            </a:extLst>
          </p:cNvPr>
          <p:cNvSpPr txBox="1"/>
          <p:nvPr/>
        </p:nvSpPr>
        <p:spPr>
          <a:xfrm>
            <a:off x="3396099" y="6596514"/>
            <a:ext cx="9509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Re-blot</a:t>
            </a:r>
          </a:p>
          <a:p>
            <a:r>
              <a:rPr kumimoji="1" lang="en-US" altLang="ja-JP" sz="800" dirty="0"/>
              <a:t>(same membrane)</a:t>
            </a:r>
            <a:endParaRPr kumimoji="1" lang="ja-JP" altLang="en-US" sz="800" dirty="0"/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8FD5B68D-3C71-1F1F-C484-A2BF692CBCFB}"/>
              </a:ext>
            </a:extLst>
          </p:cNvPr>
          <p:cNvSpPr txBox="1"/>
          <p:nvPr/>
        </p:nvSpPr>
        <p:spPr>
          <a:xfrm>
            <a:off x="684519" y="9152839"/>
            <a:ext cx="5403219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(The shadow of the membrane is not visible on the developed photograph, so the photo with the membrane placed is shown as it is.)</a:t>
            </a:r>
            <a:endParaRPr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2E9FBB80-F47B-0D3D-103A-83B2D7CC3F91}"/>
              </a:ext>
            </a:extLst>
          </p:cNvPr>
          <p:cNvSpPr txBox="1"/>
          <p:nvPr/>
        </p:nvSpPr>
        <p:spPr>
          <a:xfrm>
            <a:off x="501861" y="9364162"/>
            <a:ext cx="29097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. Uncropped image of figure 1E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F0E8C7CD-713D-512C-5EC2-27F510608F07}"/>
              </a:ext>
            </a:extLst>
          </p:cNvPr>
          <p:cNvSpPr txBox="1"/>
          <p:nvPr/>
        </p:nvSpPr>
        <p:spPr>
          <a:xfrm>
            <a:off x="508333" y="9608794"/>
            <a:ext cx="517839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portion marked by the arrow has been cropped in the main figure. 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直線矢印コネクタ 84">
            <a:extLst>
              <a:ext uri="{FF2B5EF4-FFF2-40B4-BE49-F238E27FC236}">
                <a16:creationId xmlns:a16="http://schemas.microsoft.com/office/drawing/2014/main" id="{059093E3-7017-4C9B-563E-47009E6A4495}"/>
              </a:ext>
            </a:extLst>
          </p:cNvPr>
          <p:cNvCxnSpPr>
            <a:cxnSpLocks/>
          </p:cNvCxnSpPr>
          <p:nvPr/>
        </p:nvCxnSpPr>
        <p:spPr>
          <a:xfrm flipH="1">
            <a:off x="6087738" y="8352313"/>
            <a:ext cx="500365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1830E3C6-1DD5-A03C-335F-10E480E36AE3}"/>
              </a:ext>
            </a:extLst>
          </p:cNvPr>
          <p:cNvSpPr txBox="1"/>
          <p:nvPr/>
        </p:nvSpPr>
        <p:spPr>
          <a:xfrm>
            <a:off x="1392413" y="6921458"/>
            <a:ext cx="10390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7" name="図 96" descr="白黒の写真&#10;&#10;AI 生成コンテンツは誤りを含む可能性があります。">
            <a:extLst>
              <a:ext uri="{FF2B5EF4-FFF2-40B4-BE49-F238E27FC236}">
                <a16:creationId xmlns:a16="http://schemas.microsoft.com/office/drawing/2014/main" id="{6FBA6614-5BCF-7C14-830B-E778BE677B1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49" t="7060" r="19301" b="7465"/>
          <a:stretch>
            <a:fillRect/>
          </a:stretch>
        </p:blipFill>
        <p:spPr>
          <a:xfrm>
            <a:off x="773315" y="3967303"/>
            <a:ext cx="2236471" cy="2407631"/>
          </a:xfrm>
          <a:prstGeom prst="rect">
            <a:avLst/>
          </a:prstGeom>
        </p:spPr>
      </p:pic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ED981597-A55F-CFC0-6B2A-B303B93EB773}"/>
              </a:ext>
            </a:extLst>
          </p:cNvPr>
          <p:cNvSpPr txBox="1"/>
          <p:nvPr/>
        </p:nvSpPr>
        <p:spPr>
          <a:xfrm>
            <a:off x="215844" y="4405974"/>
            <a:ext cx="5180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7FCDAD59-183B-CFFA-B165-F3362ADBF8CA}"/>
              </a:ext>
            </a:extLst>
          </p:cNvPr>
          <p:cNvSpPr txBox="1"/>
          <p:nvPr/>
        </p:nvSpPr>
        <p:spPr>
          <a:xfrm>
            <a:off x="215844" y="4579457"/>
            <a:ext cx="5180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88DFDC3C-CE77-0DCF-2343-27D425E4F09B}"/>
              </a:ext>
            </a:extLst>
          </p:cNvPr>
          <p:cNvSpPr txBox="1"/>
          <p:nvPr/>
        </p:nvSpPr>
        <p:spPr>
          <a:xfrm>
            <a:off x="265537" y="4692913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E6F0408B-EF9C-6360-5D12-4A59B0F5F529}"/>
              </a:ext>
            </a:extLst>
          </p:cNvPr>
          <p:cNvSpPr txBox="1"/>
          <p:nvPr/>
        </p:nvSpPr>
        <p:spPr>
          <a:xfrm>
            <a:off x="265537" y="4892968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EBDA5A10-A63A-D83C-FC25-5DAAEDC65E86}"/>
              </a:ext>
            </a:extLst>
          </p:cNvPr>
          <p:cNvSpPr txBox="1"/>
          <p:nvPr/>
        </p:nvSpPr>
        <p:spPr>
          <a:xfrm>
            <a:off x="265537" y="5135069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6AB0D759-811F-1DD8-49F7-EE113B2E0789}"/>
              </a:ext>
            </a:extLst>
          </p:cNvPr>
          <p:cNvSpPr txBox="1"/>
          <p:nvPr/>
        </p:nvSpPr>
        <p:spPr>
          <a:xfrm>
            <a:off x="215844" y="4279374"/>
            <a:ext cx="5180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411A3C32-279E-D201-C569-47C4ABF0FE90}"/>
              </a:ext>
            </a:extLst>
          </p:cNvPr>
          <p:cNvSpPr txBox="1"/>
          <p:nvPr/>
        </p:nvSpPr>
        <p:spPr>
          <a:xfrm>
            <a:off x="265537" y="5477197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4EC41279-72BD-E45C-CF43-984179636B88}"/>
              </a:ext>
            </a:extLst>
          </p:cNvPr>
          <p:cNvSpPr txBox="1"/>
          <p:nvPr/>
        </p:nvSpPr>
        <p:spPr>
          <a:xfrm>
            <a:off x="265537" y="5677252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A5A58C94-3C13-BD19-19E9-5B74D26FF47A}"/>
              </a:ext>
            </a:extLst>
          </p:cNvPr>
          <p:cNvSpPr txBox="1"/>
          <p:nvPr/>
        </p:nvSpPr>
        <p:spPr>
          <a:xfrm>
            <a:off x="1299096" y="3628451"/>
            <a:ext cx="10390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83D77A84-411A-1689-64AC-4826F24F188E}"/>
              </a:ext>
            </a:extLst>
          </p:cNvPr>
          <p:cNvSpPr txBox="1"/>
          <p:nvPr/>
        </p:nvSpPr>
        <p:spPr>
          <a:xfrm>
            <a:off x="1304509" y="7698843"/>
            <a:ext cx="5180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kumimoji="1" lang="en-US" altLang="ja-JP" sz="700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EB4E76CE-01F2-2E9E-199E-02E6CC500348}"/>
              </a:ext>
            </a:extLst>
          </p:cNvPr>
          <p:cNvSpPr txBox="1"/>
          <p:nvPr/>
        </p:nvSpPr>
        <p:spPr>
          <a:xfrm>
            <a:off x="1304509" y="7808826"/>
            <a:ext cx="5180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700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51F261AF-2433-0EF7-02B9-3F9F3A000A57}"/>
              </a:ext>
            </a:extLst>
          </p:cNvPr>
          <p:cNvSpPr txBox="1"/>
          <p:nvPr/>
        </p:nvSpPr>
        <p:spPr>
          <a:xfrm>
            <a:off x="1354202" y="7891802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kumimoji="1" lang="en-US" altLang="ja-JP" sz="700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90063E43-95C8-0BF0-1D06-547813F80A2B}"/>
              </a:ext>
            </a:extLst>
          </p:cNvPr>
          <p:cNvSpPr txBox="1"/>
          <p:nvPr/>
        </p:nvSpPr>
        <p:spPr>
          <a:xfrm>
            <a:off x="1354202" y="8035977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700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62EB0C13-9BF0-795A-16F1-73C36ABD6961}"/>
              </a:ext>
            </a:extLst>
          </p:cNvPr>
          <p:cNvSpPr txBox="1"/>
          <p:nvPr/>
        </p:nvSpPr>
        <p:spPr>
          <a:xfrm>
            <a:off x="1350231" y="8207367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700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3AF236F6-5217-908E-BD5E-D7B6B132C117}"/>
              </a:ext>
            </a:extLst>
          </p:cNvPr>
          <p:cNvSpPr txBox="1"/>
          <p:nvPr/>
        </p:nvSpPr>
        <p:spPr>
          <a:xfrm>
            <a:off x="1304509" y="7617963"/>
            <a:ext cx="5180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kumimoji="1" lang="en-US" altLang="ja-JP" sz="700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A6F69AA6-D87B-6276-FB49-C059DE55DCD1}"/>
              </a:ext>
            </a:extLst>
          </p:cNvPr>
          <p:cNvSpPr txBox="1"/>
          <p:nvPr/>
        </p:nvSpPr>
        <p:spPr>
          <a:xfrm>
            <a:off x="1354202" y="8407422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kumimoji="1" lang="en-US" altLang="ja-JP" sz="700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CF7EF3BF-9E3A-346B-0E95-BF077459C84C}"/>
              </a:ext>
            </a:extLst>
          </p:cNvPr>
          <p:cNvSpPr txBox="1"/>
          <p:nvPr/>
        </p:nvSpPr>
        <p:spPr>
          <a:xfrm>
            <a:off x="1354202" y="8522414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7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kumimoji="1" lang="en-US" altLang="ja-JP" sz="700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7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27446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図 28" descr="写真, モニター, テレビ, 画面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FC669B48-9355-6044-5C47-9AB472B382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8312" y="1709417"/>
            <a:ext cx="2487168" cy="1881051"/>
          </a:xfrm>
          <a:prstGeom prst="rect">
            <a:avLst/>
          </a:prstGeom>
        </p:spPr>
      </p:pic>
      <p:pic>
        <p:nvPicPr>
          <p:cNvPr id="31" name="図 30" descr="部屋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86A61E9A-D12B-5B91-F069-207BA3CE5FC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1709416"/>
            <a:ext cx="2487167" cy="18810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図 32" descr="写真, 座る, 鳥, テーブル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16B61D0E-F15D-0836-E9B6-D95605AF561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205"/>
          <a:stretch>
            <a:fillRect/>
          </a:stretch>
        </p:blipFill>
        <p:spPr>
          <a:xfrm>
            <a:off x="3533141" y="4953000"/>
            <a:ext cx="2383026" cy="19215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D948E5C-4879-2D78-BEF6-6933DDE1AE04}"/>
              </a:ext>
            </a:extLst>
          </p:cNvPr>
          <p:cNvSpPr txBox="1"/>
          <p:nvPr/>
        </p:nvSpPr>
        <p:spPr>
          <a:xfrm>
            <a:off x="1066325" y="2217054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kumimoji="1" lang="en-US" altLang="ja-JP" sz="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157B6FF-C5FE-3C16-F95A-6CE60ED0EF1E}"/>
              </a:ext>
            </a:extLst>
          </p:cNvPr>
          <p:cNvSpPr txBox="1"/>
          <p:nvPr/>
        </p:nvSpPr>
        <p:spPr>
          <a:xfrm>
            <a:off x="1066325" y="2321442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4DBFF176-09F4-20E9-0D1E-0AF59168E34D}"/>
              </a:ext>
            </a:extLst>
          </p:cNvPr>
          <p:cNvSpPr txBox="1"/>
          <p:nvPr/>
        </p:nvSpPr>
        <p:spPr>
          <a:xfrm>
            <a:off x="1109605" y="2423931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kumimoji="1" lang="en-US" altLang="ja-JP" sz="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FCDE90B4-E50B-5EBB-4366-E19393AD054B}"/>
              </a:ext>
            </a:extLst>
          </p:cNvPr>
          <p:cNvSpPr txBox="1"/>
          <p:nvPr/>
        </p:nvSpPr>
        <p:spPr>
          <a:xfrm>
            <a:off x="1109605" y="2550531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EC02D444-762D-DB70-01D2-AB1D281280E3}"/>
              </a:ext>
            </a:extLst>
          </p:cNvPr>
          <p:cNvSpPr txBox="1"/>
          <p:nvPr/>
        </p:nvSpPr>
        <p:spPr>
          <a:xfrm>
            <a:off x="1109605" y="2755509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BC1D7854-4EF8-227F-04BC-771C5C008CC9}"/>
              </a:ext>
            </a:extLst>
          </p:cNvPr>
          <p:cNvSpPr txBox="1"/>
          <p:nvPr/>
        </p:nvSpPr>
        <p:spPr>
          <a:xfrm>
            <a:off x="1109605" y="2914762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kumimoji="1" lang="en-US" altLang="ja-JP" sz="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B78ED6C-533F-053B-EDBD-C4107B54CCAC}"/>
              </a:ext>
            </a:extLst>
          </p:cNvPr>
          <p:cNvSpPr txBox="1"/>
          <p:nvPr/>
        </p:nvSpPr>
        <p:spPr>
          <a:xfrm>
            <a:off x="598159" y="3649692"/>
            <a:ext cx="5403219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(The shadow of the membrane is not visible on the developed photograph, so the photo with the membrane placed is shown as it is.)</a:t>
            </a:r>
            <a:endParaRPr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6CFC77C5-2F8B-132C-C92B-75A9D18A0E98}"/>
              </a:ext>
            </a:extLst>
          </p:cNvPr>
          <p:cNvSpPr txBox="1"/>
          <p:nvPr/>
        </p:nvSpPr>
        <p:spPr>
          <a:xfrm>
            <a:off x="4754088" y="1157420"/>
            <a:ext cx="7601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pY416 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43FB689E-8891-2DE0-8908-E5F7C4362BDA}"/>
              </a:ext>
            </a:extLst>
          </p:cNvPr>
          <p:cNvSpPr txBox="1"/>
          <p:nvPr/>
        </p:nvSpPr>
        <p:spPr>
          <a:xfrm rot="18725423">
            <a:off x="4988093" y="1434748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CB704AD1-0EB0-C784-E4BE-DAB8C7F5D44F}"/>
              </a:ext>
            </a:extLst>
          </p:cNvPr>
          <p:cNvSpPr txBox="1"/>
          <p:nvPr/>
        </p:nvSpPr>
        <p:spPr>
          <a:xfrm rot="18725423">
            <a:off x="4767860" y="1434747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tress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線矢印コネクタ 45">
            <a:extLst>
              <a:ext uri="{FF2B5EF4-FFF2-40B4-BE49-F238E27FC236}">
                <a16:creationId xmlns:a16="http://schemas.microsoft.com/office/drawing/2014/main" id="{A2F58A2A-3D0A-0BDD-A5C0-BD5A5B0D1E46}"/>
              </a:ext>
            </a:extLst>
          </p:cNvPr>
          <p:cNvCxnSpPr>
            <a:cxnSpLocks/>
          </p:cNvCxnSpPr>
          <p:nvPr/>
        </p:nvCxnSpPr>
        <p:spPr>
          <a:xfrm>
            <a:off x="4993404" y="1675756"/>
            <a:ext cx="0" cy="2394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矢印コネクタ 49">
            <a:extLst>
              <a:ext uri="{FF2B5EF4-FFF2-40B4-BE49-F238E27FC236}">
                <a16:creationId xmlns:a16="http://schemas.microsoft.com/office/drawing/2014/main" id="{DCA2357B-3047-4B9B-80A8-F13046D4FA5F}"/>
              </a:ext>
            </a:extLst>
          </p:cNvPr>
          <p:cNvCxnSpPr>
            <a:cxnSpLocks/>
          </p:cNvCxnSpPr>
          <p:nvPr/>
        </p:nvCxnSpPr>
        <p:spPr>
          <a:xfrm>
            <a:off x="5145804" y="1675756"/>
            <a:ext cx="0" cy="2394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矢印コネクタ 52">
            <a:extLst>
              <a:ext uri="{FF2B5EF4-FFF2-40B4-BE49-F238E27FC236}">
                <a16:creationId xmlns:a16="http://schemas.microsoft.com/office/drawing/2014/main" id="{071D24A9-DB67-4EA1-E53B-E5F2DFFB8F8B}"/>
              </a:ext>
            </a:extLst>
          </p:cNvPr>
          <p:cNvCxnSpPr>
            <a:cxnSpLocks/>
          </p:cNvCxnSpPr>
          <p:nvPr/>
        </p:nvCxnSpPr>
        <p:spPr>
          <a:xfrm flipH="1">
            <a:off x="5916167" y="2608597"/>
            <a:ext cx="500365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矢印コネクタ 53">
            <a:extLst>
              <a:ext uri="{FF2B5EF4-FFF2-40B4-BE49-F238E27FC236}">
                <a16:creationId xmlns:a16="http://schemas.microsoft.com/office/drawing/2014/main" id="{3D3F8FF3-3414-0C26-7A8D-C2FC48253A92}"/>
              </a:ext>
            </a:extLst>
          </p:cNvPr>
          <p:cNvCxnSpPr/>
          <p:nvPr/>
        </p:nvCxnSpPr>
        <p:spPr>
          <a:xfrm>
            <a:off x="4790358" y="3891895"/>
            <a:ext cx="0" cy="53106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099F69B-C910-50C5-5F58-D17F422D1FF6}"/>
              </a:ext>
            </a:extLst>
          </p:cNvPr>
          <p:cNvSpPr txBox="1"/>
          <p:nvPr/>
        </p:nvSpPr>
        <p:spPr>
          <a:xfrm>
            <a:off x="3803187" y="4003219"/>
            <a:ext cx="9509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Re-blot</a:t>
            </a:r>
          </a:p>
          <a:p>
            <a:r>
              <a:rPr kumimoji="1" lang="en-US" altLang="ja-JP" sz="800" dirty="0"/>
              <a:t>(same membrane)</a:t>
            </a:r>
            <a:endParaRPr kumimoji="1" lang="ja-JP" altLang="en-US" sz="800" dirty="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1004990E-6F03-59D6-3BC2-2F860CF529BE}"/>
              </a:ext>
            </a:extLst>
          </p:cNvPr>
          <p:cNvSpPr txBox="1"/>
          <p:nvPr/>
        </p:nvSpPr>
        <p:spPr>
          <a:xfrm>
            <a:off x="4940202" y="4372553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直線矢印コネクタ 58">
            <a:extLst>
              <a:ext uri="{FF2B5EF4-FFF2-40B4-BE49-F238E27FC236}">
                <a16:creationId xmlns:a16="http://schemas.microsoft.com/office/drawing/2014/main" id="{9B71DB3C-0369-1BD7-C954-056DE9E9A918}"/>
              </a:ext>
            </a:extLst>
          </p:cNvPr>
          <p:cNvCxnSpPr>
            <a:cxnSpLocks/>
          </p:cNvCxnSpPr>
          <p:nvPr/>
        </p:nvCxnSpPr>
        <p:spPr>
          <a:xfrm>
            <a:off x="5071734" y="4918052"/>
            <a:ext cx="0" cy="2394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矢印コネクタ 59">
            <a:extLst>
              <a:ext uri="{FF2B5EF4-FFF2-40B4-BE49-F238E27FC236}">
                <a16:creationId xmlns:a16="http://schemas.microsoft.com/office/drawing/2014/main" id="{3D36CC2D-9BAE-EDA2-54F1-55D3CF5590F0}"/>
              </a:ext>
            </a:extLst>
          </p:cNvPr>
          <p:cNvCxnSpPr>
            <a:cxnSpLocks/>
          </p:cNvCxnSpPr>
          <p:nvPr/>
        </p:nvCxnSpPr>
        <p:spPr>
          <a:xfrm>
            <a:off x="5224134" y="4918052"/>
            <a:ext cx="0" cy="2394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矢印コネクタ 60">
            <a:extLst>
              <a:ext uri="{FF2B5EF4-FFF2-40B4-BE49-F238E27FC236}">
                <a16:creationId xmlns:a16="http://schemas.microsoft.com/office/drawing/2014/main" id="{5FA1E141-506A-8539-9F25-2AD02F54FFB7}"/>
              </a:ext>
            </a:extLst>
          </p:cNvPr>
          <p:cNvCxnSpPr>
            <a:cxnSpLocks/>
          </p:cNvCxnSpPr>
          <p:nvPr/>
        </p:nvCxnSpPr>
        <p:spPr>
          <a:xfrm flipH="1">
            <a:off x="5969667" y="5926473"/>
            <a:ext cx="500365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E038728D-B6BB-4730-3DD5-402BF0705487}"/>
              </a:ext>
            </a:extLst>
          </p:cNvPr>
          <p:cNvSpPr txBox="1"/>
          <p:nvPr/>
        </p:nvSpPr>
        <p:spPr>
          <a:xfrm>
            <a:off x="785868" y="7196016"/>
            <a:ext cx="29177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. Uncropped image of figure 2D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74FB31B5-476A-AD03-83E5-A39148BB1C4E}"/>
              </a:ext>
            </a:extLst>
          </p:cNvPr>
          <p:cNvSpPr txBox="1"/>
          <p:nvPr/>
        </p:nvSpPr>
        <p:spPr>
          <a:xfrm>
            <a:off x="791274" y="7521148"/>
            <a:ext cx="517839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portion marked by the arrow has been cropped in the main figure.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ue to the order in which samples are run, they appear reversed left-to-right in the main figure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5F3E0AAE-EE6C-052C-6098-719F1CFE4376}"/>
              </a:ext>
            </a:extLst>
          </p:cNvPr>
          <p:cNvSpPr txBox="1"/>
          <p:nvPr/>
        </p:nvSpPr>
        <p:spPr>
          <a:xfrm rot="18725423">
            <a:off x="5070231" y="4644841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D9302C73-500D-3246-8B57-4D50AE145516}"/>
              </a:ext>
            </a:extLst>
          </p:cNvPr>
          <p:cNvSpPr txBox="1"/>
          <p:nvPr/>
        </p:nvSpPr>
        <p:spPr>
          <a:xfrm rot="18725423">
            <a:off x="4849998" y="4644840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tress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9DB5FA12-6A7E-3955-DDFC-F3FA4B83CC17}"/>
              </a:ext>
            </a:extLst>
          </p:cNvPr>
          <p:cNvSpPr txBox="1"/>
          <p:nvPr/>
        </p:nvSpPr>
        <p:spPr>
          <a:xfrm>
            <a:off x="1343768" y="1300763"/>
            <a:ext cx="10390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9AEBC439-C03D-73B6-EF60-68EFA22D14B1}"/>
              </a:ext>
            </a:extLst>
          </p:cNvPr>
          <p:cNvSpPr txBox="1"/>
          <p:nvPr/>
        </p:nvSpPr>
        <p:spPr>
          <a:xfrm>
            <a:off x="1066324" y="2149483"/>
            <a:ext cx="47320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kumimoji="1" lang="en-US" altLang="ja-JP" sz="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 descr="写真, モニター, テレビ, 画面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D34DA622-7802-0669-B5CE-E6D8F956785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823" y="4935183"/>
            <a:ext cx="2487168" cy="1881051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F44A9A7-8C7A-5553-0949-C209487D3291}"/>
              </a:ext>
            </a:extLst>
          </p:cNvPr>
          <p:cNvSpPr txBox="1"/>
          <p:nvPr/>
        </p:nvSpPr>
        <p:spPr>
          <a:xfrm>
            <a:off x="1113836" y="5442820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kumimoji="1" lang="en-US" altLang="ja-JP" sz="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7B0388D-A583-55C7-DE5A-DDA0D1EBB87B}"/>
              </a:ext>
            </a:extLst>
          </p:cNvPr>
          <p:cNvSpPr txBox="1"/>
          <p:nvPr/>
        </p:nvSpPr>
        <p:spPr>
          <a:xfrm>
            <a:off x="1113836" y="5547208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455060A-88F0-8E27-757D-CB92BD4363DA}"/>
              </a:ext>
            </a:extLst>
          </p:cNvPr>
          <p:cNvSpPr txBox="1"/>
          <p:nvPr/>
        </p:nvSpPr>
        <p:spPr>
          <a:xfrm>
            <a:off x="1157116" y="5649697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kumimoji="1" lang="en-US" altLang="ja-JP" sz="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58B7A46-A10B-39C6-4D94-4551622D1060}"/>
              </a:ext>
            </a:extLst>
          </p:cNvPr>
          <p:cNvSpPr txBox="1"/>
          <p:nvPr/>
        </p:nvSpPr>
        <p:spPr>
          <a:xfrm>
            <a:off x="1157116" y="5776297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497335A-91A7-88BC-8FE8-B77F4716307A}"/>
              </a:ext>
            </a:extLst>
          </p:cNvPr>
          <p:cNvSpPr txBox="1"/>
          <p:nvPr/>
        </p:nvSpPr>
        <p:spPr>
          <a:xfrm>
            <a:off x="1157116" y="5981275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CEFF251-AEE0-C018-18D2-C9350234E702}"/>
              </a:ext>
            </a:extLst>
          </p:cNvPr>
          <p:cNvSpPr txBox="1"/>
          <p:nvPr/>
        </p:nvSpPr>
        <p:spPr>
          <a:xfrm>
            <a:off x="1157116" y="6140528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kumimoji="1" lang="en-US" altLang="ja-JP" sz="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A6092BF-12FB-0795-D368-FC557E9EAF1E}"/>
              </a:ext>
            </a:extLst>
          </p:cNvPr>
          <p:cNvSpPr txBox="1"/>
          <p:nvPr/>
        </p:nvSpPr>
        <p:spPr>
          <a:xfrm>
            <a:off x="1391279" y="4526529"/>
            <a:ext cx="10390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F943344-722D-C43F-ADBD-16A421A05A9B}"/>
              </a:ext>
            </a:extLst>
          </p:cNvPr>
          <p:cNvSpPr txBox="1"/>
          <p:nvPr/>
        </p:nvSpPr>
        <p:spPr>
          <a:xfrm>
            <a:off x="1113835" y="5375249"/>
            <a:ext cx="47320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kumimoji="1" lang="en-US" altLang="ja-JP" sz="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04497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AEC29A36-8B53-4E50-1E76-1376E567FA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68" t="9326" r="9726" b="18982"/>
          <a:stretch>
            <a:fillRect/>
          </a:stretch>
        </p:blipFill>
        <p:spPr>
          <a:xfrm>
            <a:off x="1264775" y="3803433"/>
            <a:ext cx="1857573" cy="1651924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0EFD8AF1-02AA-DCD4-9479-1340F41F7EC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85" t="8079" r="8030" b="18584"/>
          <a:stretch>
            <a:fillRect/>
          </a:stretch>
        </p:blipFill>
        <p:spPr>
          <a:xfrm>
            <a:off x="3482573" y="3803433"/>
            <a:ext cx="2012226" cy="1736958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2C774366-0AEF-2DCA-8C5B-BB3B3B63236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887" t="13143" r="14433" b="8954"/>
          <a:stretch>
            <a:fillRect/>
          </a:stretch>
        </p:blipFill>
        <p:spPr>
          <a:xfrm>
            <a:off x="4059377" y="1189140"/>
            <a:ext cx="1115320" cy="13302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CFC1C22-3AC6-2637-952C-62F77011C49B}"/>
              </a:ext>
            </a:extLst>
          </p:cNvPr>
          <p:cNvSpPr txBox="1"/>
          <p:nvPr/>
        </p:nvSpPr>
        <p:spPr>
          <a:xfrm>
            <a:off x="1622955" y="893571"/>
            <a:ext cx="10390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B9DDCB0-4F04-E631-A927-18C4D5A388D3}"/>
              </a:ext>
            </a:extLst>
          </p:cNvPr>
          <p:cNvSpPr txBox="1"/>
          <p:nvPr/>
        </p:nvSpPr>
        <p:spPr>
          <a:xfrm>
            <a:off x="1175586" y="1306763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0CEE7CE-3274-BADC-490F-C20F20650B0B}"/>
              </a:ext>
            </a:extLst>
          </p:cNvPr>
          <p:cNvSpPr txBox="1"/>
          <p:nvPr/>
        </p:nvSpPr>
        <p:spPr>
          <a:xfrm>
            <a:off x="1175586" y="1403531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3E117D8-F5DC-0D5F-1CA6-83266E8D83A2}"/>
              </a:ext>
            </a:extLst>
          </p:cNvPr>
          <p:cNvSpPr txBox="1"/>
          <p:nvPr/>
        </p:nvSpPr>
        <p:spPr>
          <a:xfrm>
            <a:off x="1218866" y="1485700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9DC3FD1-4282-5782-1CD2-52656E766EB2}"/>
              </a:ext>
            </a:extLst>
          </p:cNvPr>
          <p:cNvSpPr txBox="1"/>
          <p:nvPr/>
        </p:nvSpPr>
        <p:spPr>
          <a:xfrm>
            <a:off x="1218866" y="1637346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93925DE-5087-C27B-2964-732736BF3841}"/>
              </a:ext>
            </a:extLst>
          </p:cNvPr>
          <p:cNvSpPr txBox="1"/>
          <p:nvPr/>
        </p:nvSpPr>
        <p:spPr>
          <a:xfrm>
            <a:off x="1218866" y="1766478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0038222-3109-B147-DF05-398CA6319D1D}"/>
              </a:ext>
            </a:extLst>
          </p:cNvPr>
          <p:cNvSpPr txBox="1"/>
          <p:nvPr/>
        </p:nvSpPr>
        <p:spPr>
          <a:xfrm>
            <a:off x="1218866" y="2079383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D00AAB7-27D3-E92A-375B-9598023F53AA}"/>
              </a:ext>
            </a:extLst>
          </p:cNvPr>
          <p:cNvSpPr txBox="1"/>
          <p:nvPr/>
        </p:nvSpPr>
        <p:spPr>
          <a:xfrm>
            <a:off x="1181986" y="1225536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554ADD8-34D8-8750-2FF7-8EA824A0078C}"/>
              </a:ext>
            </a:extLst>
          </p:cNvPr>
          <p:cNvSpPr txBox="1"/>
          <p:nvPr/>
        </p:nvSpPr>
        <p:spPr>
          <a:xfrm rot="19091558">
            <a:off x="4263851" y="956072"/>
            <a:ext cx="5279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Empty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B099C05-83C4-AA4D-7A64-0761F25896F2}"/>
              </a:ext>
            </a:extLst>
          </p:cNvPr>
          <p:cNvSpPr txBox="1"/>
          <p:nvPr/>
        </p:nvSpPr>
        <p:spPr>
          <a:xfrm rot="19091558">
            <a:off x="4373657" y="913760"/>
            <a:ext cx="655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F527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0926300-028A-A95C-EE36-2DFEA843F04F}"/>
              </a:ext>
            </a:extLst>
          </p:cNvPr>
          <p:cNvSpPr txBox="1"/>
          <p:nvPr/>
        </p:nvSpPr>
        <p:spPr>
          <a:xfrm rot="19091558">
            <a:off x="4647279" y="943742"/>
            <a:ext cx="5279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Empty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F7A851B-CBAA-9BA0-6E5F-C27EBF19F416}"/>
              </a:ext>
            </a:extLst>
          </p:cNvPr>
          <p:cNvSpPr txBox="1"/>
          <p:nvPr/>
        </p:nvSpPr>
        <p:spPr>
          <a:xfrm rot="19091558">
            <a:off x="4749127" y="913759"/>
            <a:ext cx="655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F527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C43F555-5EC9-3AEF-90C2-0D3F7F1163E6}"/>
              </a:ext>
            </a:extLst>
          </p:cNvPr>
          <p:cNvSpPr txBox="1"/>
          <p:nvPr/>
        </p:nvSpPr>
        <p:spPr>
          <a:xfrm>
            <a:off x="4340431" y="637949"/>
            <a:ext cx="5027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ytosol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AE527F0-5ADE-9D87-2E09-8E0E3C0549D6}"/>
              </a:ext>
            </a:extLst>
          </p:cNvPr>
          <p:cNvSpPr txBox="1"/>
          <p:nvPr/>
        </p:nvSpPr>
        <p:spPr>
          <a:xfrm>
            <a:off x="4785609" y="543110"/>
            <a:ext cx="651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6F4CC27-7368-6B6D-F8EA-A617EC4CC1B4}"/>
              </a:ext>
            </a:extLst>
          </p:cNvPr>
          <p:cNvSpPr txBox="1"/>
          <p:nvPr/>
        </p:nvSpPr>
        <p:spPr>
          <a:xfrm>
            <a:off x="3452749" y="466166"/>
            <a:ext cx="7957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l-GR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tdTomato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CF0087C9-3CC5-E931-2ECF-C49B95DBC499}"/>
              </a:ext>
            </a:extLst>
          </p:cNvPr>
          <p:cNvCxnSpPr>
            <a:cxnSpLocks/>
          </p:cNvCxnSpPr>
          <p:nvPr/>
        </p:nvCxnSpPr>
        <p:spPr>
          <a:xfrm>
            <a:off x="4508280" y="838004"/>
            <a:ext cx="27732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DF76B4B3-623C-A1AA-AC23-E44A58D396E3}"/>
              </a:ext>
            </a:extLst>
          </p:cNvPr>
          <p:cNvCxnSpPr>
            <a:cxnSpLocks/>
          </p:cNvCxnSpPr>
          <p:nvPr/>
        </p:nvCxnSpPr>
        <p:spPr>
          <a:xfrm>
            <a:off x="4916172" y="838004"/>
            <a:ext cx="27732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3CA720A0-B224-4807-34F4-9081CC585769}"/>
              </a:ext>
            </a:extLst>
          </p:cNvPr>
          <p:cNvCxnSpPr>
            <a:cxnSpLocks/>
          </p:cNvCxnSpPr>
          <p:nvPr/>
        </p:nvCxnSpPr>
        <p:spPr>
          <a:xfrm flipH="1">
            <a:off x="5076772" y="1547557"/>
            <a:ext cx="500365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8C1F9444-914D-0C4F-055D-9A5F6133B33E}"/>
              </a:ext>
            </a:extLst>
          </p:cNvPr>
          <p:cNvSpPr txBox="1"/>
          <p:nvPr/>
        </p:nvSpPr>
        <p:spPr>
          <a:xfrm>
            <a:off x="2926002" y="2555834"/>
            <a:ext cx="10534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onger exposur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o show the shape 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of membran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58D4B7CC-FA6D-6D6D-4609-BBC4E86CE3A8}"/>
              </a:ext>
            </a:extLst>
          </p:cNvPr>
          <p:cNvSpPr txBox="1"/>
          <p:nvPr/>
        </p:nvSpPr>
        <p:spPr>
          <a:xfrm>
            <a:off x="4000118" y="2555833"/>
            <a:ext cx="13211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horter exposur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hown in the main figur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図 35">
            <a:extLst>
              <a:ext uri="{FF2B5EF4-FFF2-40B4-BE49-F238E27FC236}">
                <a16:creationId xmlns:a16="http://schemas.microsoft.com/office/drawing/2014/main" id="{CAC9945F-9D09-5234-693C-97C8017CB68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07" t="17671" r="19085" b="14243"/>
          <a:stretch>
            <a:fillRect/>
          </a:stretch>
        </p:blipFill>
        <p:spPr>
          <a:xfrm>
            <a:off x="2786126" y="1201348"/>
            <a:ext cx="1102783" cy="1330299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id="{4DF117CA-24FC-C2E8-BFEC-B052C072122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21" t="18273" r="18576" b="13759"/>
          <a:stretch>
            <a:fillRect/>
          </a:stretch>
        </p:blipFill>
        <p:spPr>
          <a:xfrm>
            <a:off x="1603927" y="1201348"/>
            <a:ext cx="1102695" cy="1318091"/>
          </a:xfrm>
          <a:prstGeom prst="rect">
            <a:avLst/>
          </a:prstGeom>
        </p:spPr>
      </p:pic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F05C4F43-2A68-73C8-98F4-53C06F1BD67F}"/>
              </a:ext>
            </a:extLst>
          </p:cNvPr>
          <p:cNvSpPr txBox="1"/>
          <p:nvPr/>
        </p:nvSpPr>
        <p:spPr>
          <a:xfrm>
            <a:off x="813710" y="4020342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7A26B8E0-927C-F26B-2AA1-3FE78B2C5EF4}"/>
              </a:ext>
            </a:extLst>
          </p:cNvPr>
          <p:cNvSpPr txBox="1"/>
          <p:nvPr/>
        </p:nvSpPr>
        <p:spPr>
          <a:xfrm>
            <a:off x="813710" y="4137986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7DB91034-AF8A-2254-BD94-DBCF7D7473FC}"/>
              </a:ext>
            </a:extLst>
          </p:cNvPr>
          <p:cNvSpPr txBox="1"/>
          <p:nvPr/>
        </p:nvSpPr>
        <p:spPr>
          <a:xfrm>
            <a:off x="856990" y="4232855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AE8C6660-6671-39ED-F4A2-E9BAB28827FC}"/>
              </a:ext>
            </a:extLst>
          </p:cNvPr>
          <p:cNvSpPr txBox="1"/>
          <p:nvPr/>
        </p:nvSpPr>
        <p:spPr>
          <a:xfrm>
            <a:off x="856990" y="4409447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8FA31FCA-E814-9C02-5D47-8AC5FDB22895}"/>
              </a:ext>
            </a:extLst>
          </p:cNvPr>
          <p:cNvSpPr txBox="1"/>
          <p:nvPr/>
        </p:nvSpPr>
        <p:spPr>
          <a:xfrm>
            <a:off x="856990" y="4614630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066494A4-FD91-72A6-85BB-01332CA1210D}"/>
              </a:ext>
            </a:extLst>
          </p:cNvPr>
          <p:cNvSpPr txBox="1"/>
          <p:nvPr/>
        </p:nvSpPr>
        <p:spPr>
          <a:xfrm>
            <a:off x="856990" y="5059649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5F230778-4CB5-900A-E381-B0AD319B71F0}"/>
              </a:ext>
            </a:extLst>
          </p:cNvPr>
          <p:cNvSpPr txBox="1"/>
          <p:nvPr/>
        </p:nvSpPr>
        <p:spPr>
          <a:xfrm>
            <a:off x="813710" y="3916604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42AE1607-BF3E-2BAC-5DF5-869920D67312}"/>
              </a:ext>
            </a:extLst>
          </p:cNvPr>
          <p:cNvSpPr txBox="1"/>
          <p:nvPr/>
        </p:nvSpPr>
        <p:spPr>
          <a:xfrm>
            <a:off x="4380846" y="3118465"/>
            <a:ext cx="5713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l-GR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c-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B4BF7CAB-BF39-832B-7E2E-0F57BE48C16E}"/>
              </a:ext>
            </a:extLst>
          </p:cNvPr>
          <p:cNvSpPr txBox="1"/>
          <p:nvPr/>
        </p:nvSpPr>
        <p:spPr>
          <a:xfrm rot="19091558">
            <a:off x="4124945" y="3633159"/>
            <a:ext cx="655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F527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3D37094D-E308-FEC8-DCC1-985B07CB7910}"/>
              </a:ext>
            </a:extLst>
          </p:cNvPr>
          <p:cNvSpPr txBox="1"/>
          <p:nvPr/>
        </p:nvSpPr>
        <p:spPr>
          <a:xfrm rot="19091558">
            <a:off x="4514772" y="3663141"/>
            <a:ext cx="5279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Empty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B7C4B296-E222-7BA6-75D5-2C0189985F2C}"/>
              </a:ext>
            </a:extLst>
          </p:cNvPr>
          <p:cNvSpPr txBox="1"/>
          <p:nvPr/>
        </p:nvSpPr>
        <p:spPr>
          <a:xfrm rot="19091558">
            <a:off x="4668576" y="3631097"/>
            <a:ext cx="655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F527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AE69C909-1F52-47B7-D1A3-580C0D286F93}"/>
              </a:ext>
            </a:extLst>
          </p:cNvPr>
          <p:cNvSpPr txBox="1"/>
          <p:nvPr/>
        </p:nvSpPr>
        <p:spPr>
          <a:xfrm>
            <a:off x="4091719" y="3357348"/>
            <a:ext cx="5027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ytosol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049CAEEE-0DEB-3475-FBAC-7424312F86A3}"/>
              </a:ext>
            </a:extLst>
          </p:cNvPr>
          <p:cNvSpPr txBox="1"/>
          <p:nvPr/>
        </p:nvSpPr>
        <p:spPr>
          <a:xfrm>
            <a:off x="4653102" y="3262509"/>
            <a:ext cx="651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ADE8963A-8DA1-9A56-FDD2-0399C8867071}"/>
              </a:ext>
            </a:extLst>
          </p:cNvPr>
          <p:cNvCxnSpPr>
            <a:cxnSpLocks/>
          </p:cNvCxnSpPr>
          <p:nvPr/>
        </p:nvCxnSpPr>
        <p:spPr>
          <a:xfrm>
            <a:off x="4259568" y="3557403"/>
            <a:ext cx="27732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B70F0E1D-0D63-459E-8EF4-9676B400FAF2}"/>
              </a:ext>
            </a:extLst>
          </p:cNvPr>
          <p:cNvCxnSpPr>
            <a:cxnSpLocks/>
          </p:cNvCxnSpPr>
          <p:nvPr/>
        </p:nvCxnSpPr>
        <p:spPr>
          <a:xfrm>
            <a:off x="4783665" y="3557403"/>
            <a:ext cx="27732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3B1BF858-FB6B-C1A3-A9A0-E3A0D8C7AF51}"/>
              </a:ext>
            </a:extLst>
          </p:cNvPr>
          <p:cNvSpPr txBox="1"/>
          <p:nvPr/>
        </p:nvSpPr>
        <p:spPr>
          <a:xfrm rot="19091558">
            <a:off x="4001280" y="3637538"/>
            <a:ext cx="5279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Empty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DDB16625-EA4B-27C2-CE92-89A26C2EE25F}"/>
              </a:ext>
            </a:extLst>
          </p:cNvPr>
          <p:cNvSpPr txBox="1"/>
          <p:nvPr/>
        </p:nvSpPr>
        <p:spPr>
          <a:xfrm>
            <a:off x="1621850" y="3499050"/>
            <a:ext cx="10390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直線矢印コネクタ 60">
            <a:extLst>
              <a:ext uri="{FF2B5EF4-FFF2-40B4-BE49-F238E27FC236}">
                <a16:creationId xmlns:a16="http://schemas.microsoft.com/office/drawing/2014/main" id="{CD3E57A5-BDFC-6B51-0EDF-D00A9DECBB8A}"/>
              </a:ext>
            </a:extLst>
          </p:cNvPr>
          <p:cNvCxnSpPr>
            <a:cxnSpLocks/>
          </p:cNvCxnSpPr>
          <p:nvPr/>
        </p:nvCxnSpPr>
        <p:spPr>
          <a:xfrm flipH="1">
            <a:off x="5346787" y="4594113"/>
            <a:ext cx="500365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3" name="図 62">
            <a:extLst>
              <a:ext uri="{FF2B5EF4-FFF2-40B4-BE49-F238E27FC236}">
                <a16:creationId xmlns:a16="http://schemas.microsoft.com/office/drawing/2014/main" id="{8E5A910C-65AF-8C69-6538-4A89E5E2DEE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27" t="7464" r="22309" b="-2419"/>
          <a:stretch>
            <a:fillRect/>
          </a:stretch>
        </p:blipFill>
        <p:spPr>
          <a:xfrm>
            <a:off x="4047497" y="6787534"/>
            <a:ext cx="1280494" cy="17080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9" name="図 68">
            <a:extLst>
              <a:ext uri="{FF2B5EF4-FFF2-40B4-BE49-F238E27FC236}">
                <a16:creationId xmlns:a16="http://schemas.microsoft.com/office/drawing/2014/main" id="{A8B1AA2D-8288-757D-C41D-8AC14D16650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38" t="14451" r="23331" b="19039"/>
          <a:stretch>
            <a:fillRect/>
          </a:stretch>
        </p:blipFill>
        <p:spPr>
          <a:xfrm>
            <a:off x="1170587" y="6787535"/>
            <a:ext cx="1321675" cy="17080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1" name="図 70">
            <a:extLst>
              <a:ext uri="{FF2B5EF4-FFF2-40B4-BE49-F238E27FC236}">
                <a16:creationId xmlns:a16="http://schemas.microsoft.com/office/drawing/2014/main" id="{478A01F1-0CFB-7E22-888A-86805BAC673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48" t="13834" r="25954" b="14590"/>
          <a:stretch>
            <a:fillRect/>
          </a:stretch>
        </p:blipFill>
        <p:spPr>
          <a:xfrm>
            <a:off x="2594752" y="6787534"/>
            <a:ext cx="1350255" cy="17080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3851E8D4-D05D-4577-5BC7-194D2A46F0D0}"/>
              </a:ext>
            </a:extLst>
          </p:cNvPr>
          <p:cNvSpPr txBox="1"/>
          <p:nvPr/>
        </p:nvSpPr>
        <p:spPr>
          <a:xfrm>
            <a:off x="753440" y="6973797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125EB4BD-1972-412D-A020-838F9F1DFB7E}"/>
              </a:ext>
            </a:extLst>
          </p:cNvPr>
          <p:cNvSpPr txBox="1"/>
          <p:nvPr/>
        </p:nvSpPr>
        <p:spPr>
          <a:xfrm>
            <a:off x="753440" y="7080725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1D23E9D6-1D98-37B9-A7EE-50C561590796}"/>
              </a:ext>
            </a:extLst>
          </p:cNvPr>
          <p:cNvSpPr txBox="1"/>
          <p:nvPr/>
        </p:nvSpPr>
        <p:spPr>
          <a:xfrm>
            <a:off x="796720" y="7182271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642DFD81-790A-A826-60E5-3B91085500B2}"/>
              </a:ext>
            </a:extLst>
          </p:cNvPr>
          <p:cNvSpPr txBox="1"/>
          <p:nvPr/>
        </p:nvSpPr>
        <p:spPr>
          <a:xfrm>
            <a:off x="782628" y="7387454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976C9779-05E3-4025-ABA6-44431729401A}"/>
              </a:ext>
            </a:extLst>
          </p:cNvPr>
          <p:cNvSpPr txBox="1"/>
          <p:nvPr/>
        </p:nvSpPr>
        <p:spPr>
          <a:xfrm>
            <a:off x="782628" y="7595326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E9DB81AD-2B19-F1C7-BEDB-1D1D5775EADB}"/>
              </a:ext>
            </a:extLst>
          </p:cNvPr>
          <p:cNvSpPr txBox="1"/>
          <p:nvPr/>
        </p:nvSpPr>
        <p:spPr>
          <a:xfrm>
            <a:off x="782628" y="7984431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87510CBA-E70D-F408-CD58-3A59A162D69E}"/>
              </a:ext>
            </a:extLst>
          </p:cNvPr>
          <p:cNvSpPr txBox="1"/>
          <p:nvPr/>
        </p:nvSpPr>
        <p:spPr>
          <a:xfrm>
            <a:off x="759840" y="6892570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11790461-69A8-2B91-D539-D672A55B0F7C}"/>
              </a:ext>
            </a:extLst>
          </p:cNvPr>
          <p:cNvSpPr txBox="1"/>
          <p:nvPr/>
        </p:nvSpPr>
        <p:spPr>
          <a:xfrm>
            <a:off x="2802719" y="8522571"/>
            <a:ext cx="10534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onger exposur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o show the shape 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of membran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60DCFD21-E075-C2E5-C7D8-0E6B0D8C29A6}"/>
              </a:ext>
            </a:extLst>
          </p:cNvPr>
          <p:cNvSpPr txBox="1"/>
          <p:nvPr/>
        </p:nvSpPr>
        <p:spPr>
          <a:xfrm>
            <a:off x="4095688" y="8545762"/>
            <a:ext cx="13211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horter exposur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hown in the main figur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8598E254-8DCE-39EB-F0BF-B9574917632E}"/>
              </a:ext>
            </a:extLst>
          </p:cNvPr>
          <p:cNvSpPr txBox="1"/>
          <p:nvPr/>
        </p:nvSpPr>
        <p:spPr>
          <a:xfrm>
            <a:off x="3680266" y="6039222"/>
            <a:ext cx="5294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l-GR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Flag</a:t>
            </a: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EA643FDD-91DA-C4A1-88A9-1A242D0912B7}"/>
              </a:ext>
            </a:extLst>
          </p:cNvPr>
          <p:cNvSpPr txBox="1"/>
          <p:nvPr/>
        </p:nvSpPr>
        <p:spPr>
          <a:xfrm rot="19091558">
            <a:off x="4377758" y="6441620"/>
            <a:ext cx="655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F527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C973346D-941B-C0CC-A520-6AF0779DCEC5}"/>
              </a:ext>
            </a:extLst>
          </p:cNvPr>
          <p:cNvSpPr txBox="1"/>
          <p:nvPr/>
        </p:nvSpPr>
        <p:spPr>
          <a:xfrm rot="19091558">
            <a:off x="4767585" y="6471602"/>
            <a:ext cx="5279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Empty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4627A3AC-997D-F37D-7BE6-E59554C8D79A}"/>
              </a:ext>
            </a:extLst>
          </p:cNvPr>
          <p:cNvSpPr txBox="1"/>
          <p:nvPr/>
        </p:nvSpPr>
        <p:spPr>
          <a:xfrm rot="19091558">
            <a:off x="4921389" y="6439558"/>
            <a:ext cx="655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F527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9E771820-37CE-0314-7F21-538A955D2D95}"/>
              </a:ext>
            </a:extLst>
          </p:cNvPr>
          <p:cNvSpPr txBox="1"/>
          <p:nvPr/>
        </p:nvSpPr>
        <p:spPr>
          <a:xfrm>
            <a:off x="4344532" y="6165809"/>
            <a:ext cx="5027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ytosol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1D507131-CD58-C20F-DD28-59C4FF493B8D}"/>
              </a:ext>
            </a:extLst>
          </p:cNvPr>
          <p:cNvSpPr txBox="1"/>
          <p:nvPr/>
        </p:nvSpPr>
        <p:spPr>
          <a:xfrm>
            <a:off x="4905915" y="6070970"/>
            <a:ext cx="651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直線コネクタ 87">
            <a:extLst>
              <a:ext uri="{FF2B5EF4-FFF2-40B4-BE49-F238E27FC236}">
                <a16:creationId xmlns:a16="http://schemas.microsoft.com/office/drawing/2014/main" id="{2757E3F3-A5B3-8291-2466-55BA258F7586}"/>
              </a:ext>
            </a:extLst>
          </p:cNvPr>
          <p:cNvCxnSpPr>
            <a:cxnSpLocks/>
          </p:cNvCxnSpPr>
          <p:nvPr/>
        </p:nvCxnSpPr>
        <p:spPr>
          <a:xfrm>
            <a:off x="4512381" y="6365864"/>
            <a:ext cx="27732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E0059880-2F5C-B803-9E72-6A052A056A0E}"/>
              </a:ext>
            </a:extLst>
          </p:cNvPr>
          <p:cNvCxnSpPr>
            <a:cxnSpLocks/>
          </p:cNvCxnSpPr>
          <p:nvPr/>
        </p:nvCxnSpPr>
        <p:spPr>
          <a:xfrm>
            <a:off x="5036478" y="6365864"/>
            <a:ext cx="27732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BE3319DC-444A-AA40-6FCE-D5AB97865B7E}"/>
              </a:ext>
            </a:extLst>
          </p:cNvPr>
          <p:cNvSpPr txBox="1"/>
          <p:nvPr/>
        </p:nvSpPr>
        <p:spPr>
          <a:xfrm rot="19091558">
            <a:off x="4254093" y="6445999"/>
            <a:ext cx="5279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Empty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直線矢印コネクタ 90">
            <a:extLst>
              <a:ext uri="{FF2B5EF4-FFF2-40B4-BE49-F238E27FC236}">
                <a16:creationId xmlns:a16="http://schemas.microsoft.com/office/drawing/2014/main" id="{806BFD84-76EC-DF17-D63F-B129B24412DF}"/>
              </a:ext>
            </a:extLst>
          </p:cNvPr>
          <p:cNvCxnSpPr>
            <a:cxnSpLocks/>
          </p:cNvCxnSpPr>
          <p:nvPr/>
        </p:nvCxnSpPr>
        <p:spPr>
          <a:xfrm flipH="1">
            <a:off x="5342267" y="7387454"/>
            <a:ext cx="500365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C2C234F2-F1EC-2FD9-1449-C25C256E8776}"/>
              </a:ext>
            </a:extLst>
          </p:cNvPr>
          <p:cNvSpPr txBox="1"/>
          <p:nvPr/>
        </p:nvSpPr>
        <p:spPr>
          <a:xfrm>
            <a:off x="828457" y="9181371"/>
            <a:ext cx="29177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. Uncropped image of figure 3B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752D5953-A4E5-D025-71A3-A4955DE166BB}"/>
              </a:ext>
            </a:extLst>
          </p:cNvPr>
          <p:cNvSpPr txBox="1"/>
          <p:nvPr/>
        </p:nvSpPr>
        <p:spPr>
          <a:xfrm>
            <a:off x="839803" y="9493191"/>
            <a:ext cx="517839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portion marked by the arrow has been cropped in the main figure. 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D6FB2FEC-BCDC-1DEE-0A03-1FACBDEF32DF}"/>
              </a:ext>
            </a:extLst>
          </p:cNvPr>
          <p:cNvSpPr txBox="1"/>
          <p:nvPr/>
        </p:nvSpPr>
        <p:spPr>
          <a:xfrm>
            <a:off x="1298060" y="6479757"/>
            <a:ext cx="10390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18312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8F50E614-0ACC-66FF-315D-87B42A539E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09" t="8028" r="8716" b="20946"/>
          <a:stretch>
            <a:fillRect/>
          </a:stretch>
        </p:blipFill>
        <p:spPr>
          <a:xfrm>
            <a:off x="958736" y="3687390"/>
            <a:ext cx="2135688" cy="1903174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6EC0A445-409A-01A4-D558-113D185222D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43" t="8362" r="6420" b="21483"/>
          <a:stretch>
            <a:fillRect/>
          </a:stretch>
        </p:blipFill>
        <p:spPr>
          <a:xfrm>
            <a:off x="3202498" y="3701017"/>
            <a:ext cx="2256519" cy="190962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DBFFC4A1-F5E6-63C5-4B81-E7894FA47DB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15" t="12146" r="24310" b="12530"/>
          <a:stretch>
            <a:fillRect/>
          </a:stretch>
        </p:blipFill>
        <p:spPr>
          <a:xfrm>
            <a:off x="2223243" y="1310494"/>
            <a:ext cx="1163239" cy="13260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C6692BC3-F150-8277-3FA7-F318401FDD1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56" t="14330" r="30555" b="19062"/>
          <a:stretch>
            <a:fillRect/>
          </a:stretch>
        </p:blipFill>
        <p:spPr>
          <a:xfrm>
            <a:off x="3515189" y="1310492"/>
            <a:ext cx="1079424" cy="13260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41247E70-3F99-FB2C-33F5-A18A8895E26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64" t="12571" r="28439" b="14660"/>
          <a:stretch>
            <a:fillRect/>
          </a:stretch>
        </p:blipFill>
        <p:spPr>
          <a:xfrm>
            <a:off x="1045592" y="1310493"/>
            <a:ext cx="1079424" cy="13260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18C9D5A-0602-C6E3-1E35-E44FBF0F30F1}"/>
              </a:ext>
            </a:extLst>
          </p:cNvPr>
          <p:cNvSpPr txBox="1"/>
          <p:nvPr/>
        </p:nvSpPr>
        <p:spPr>
          <a:xfrm>
            <a:off x="2289318" y="2636520"/>
            <a:ext cx="10534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onger exposur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o show the shape 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of membran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60AE867-740D-0CE1-71F5-D7E6B7933434}"/>
              </a:ext>
            </a:extLst>
          </p:cNvPr>
          <p:cNvSpPr txBox="1"/>
          <p:nvPr/>
        </p:nvSpPr>
        <p:spPr>
          <a:xfrm>
            <a:off x="3411790" y="2636519"/>
            <a:ext cx="13211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horter exposur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hown in the main figur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8E04DF7-3DED-139E-B2D9-573420A7DF80}"/>
              </a:ext>
            </a:extLst>
          </p:cNvPr>
          <p:cNvSpPr txBox="1"/>
          <p:nvPr/>
        </p:nvSpPr>
        <p:spPr>
          <a:xfrm>
            <a:off x="572386" y="1391719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5094617-E787-DFA6-AFD8-C309F1ABBE48}"/>
              </a:ext>
            </a:extLst>
          </p:cNvPr>
          <p:cNvSpPr txBox="1"/>
          <p:nvPr/>
        </p:nvSpPr>
        <p:spPr>
          <a:xfrm>
            <a:off x="572386" y="1488487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FCFC774-43C8-260B-A521-8613817E468E}"/>
              </a:ext>
            </a:extLst>
          </p:cNvPr>
          <p:cNvSpPr txBox="1"/>
          <p:nvPr/>
        </p:nvSpPr>
        <p:spPr>
          <a:xfrm>
            <a:off x="615666" y="1570656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0FF51BF-78FC-F646-F799-B02F5A78C1A8}"/>
              </a:ext>
            </a:extLst>
          </p:cNvPr>
          <p:cNvSpPr txBox="1"/>
          <p:nvPr/>
        </p:nvSpPr>
        <p:spPr>
          <a:xfrm>
            <a:off x="615666" y="1722302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F929D75-1948-8596-D6BA-07C3A1BE2116}"/>
              </a:ext>
            </a:extLst>
          </p:cNvPr>
          <p:cNvSpPr txBox="1"/>
          <p:nvPr/>
        </p:nvSpPr>
        <p:spPr>
          <a:xfrm>
            <a:off x="615666" y="1851434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D00ADB9-9AA5-FC3B-6689-4243FE0EBAC3}"/>
              </a:ext>
            </a:extLst>
          </p:cNvPr>
          <p:cNvSpPr txBox="1"/>
          <p:nvPr/>
        </p:nvSpPr>
        <p:spPr>
          <a:xfrm>
            <a:off x="615666" y="2164339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B96EFA4-241B-A5A7-379B-DAAC42EF486D}"/>
              </a:ext>
            </a:extLst>
          </p:cNvPr>
          <p:cNvSpPr txBox="1"/>
          <p:nvPr/>
        </p:nvSpPr>
        <p:spPr>
          <a:xfrm>
            <a:off x="578786" y="1310492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0D1DCB7-AB05-592A-0F3D-0555FE08F729}"/>
              </a:ext>
            </a:extLst>
          </p:cNvPr>
          <p:cNvSpPr txBox="1"/>
          <p:nvPr/>
        </p:nvSpPr>
        <p:spPr>
          <a:xfrm>
            <a:off x="2726303" y="628064"/>
            <a:ext cx="7957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l-GR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Flottilin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0F499E8-8AAB-28A8-B337-B87C92D0527E}"/>
              </a:ext>
            </a:extLst>
          </p:cNvPr>
          <p:cNvSpPr txBox="1"/>
          <p:nvPr/>
        </p:nvSpPr>
        <p:spPr>
          <a:xfrm rot="19091558">
            <a:off x="3772379" y="998714"/>
            <a:ext cx="655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F527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B5C737A-9CA5-1CB7-6992-503647A65533}"/>
              </a:ext>
            </a:extLst>
          </p:cNvPr>
          <p:cNvSpPr txBox="1"/>
          <p:nvPr/>
        </p:nvSpPr>
        <p:spPr>
          <a:xfrm rot="19091558">
            <a:off x="4177446" y="1028696"/>
            <a:ext cx="5279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Empty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F5DD16C-E9CF-B8B4-97C2-65ECF3BF2439}"/>
              </a:ext>
            </a:extLst>
          </p:cNvPr>
          <p:cNvSpPr txBox="1"/>
          <p:nvPr/>
        </p:nvSpPr>
        <p:spPr>
          <a:xfrm rot="19091558">
            <a:off x="4285530" y="996652"/>
            <a:ext cx="655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F527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A40B4D3-65AB-3F58-BB5E-BA7E38AA68ED}"/>
              </a:ext>
            </a:extLst>
          </p:cNvPr>
          <p:cNvSpPr txBox="1"/>
          <p:nvPr/>
        </p:nvSpPr>
        <p:spPr>
          <a:xfrm>
            <a:off x="3708673" y="722903"/>
            <a:ext cx="5027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ytosol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50941B2D-DB6E-B8D5-81B6-990F3F7C8A36}"/>
              </a:ext>
            </a:extLst>
          </p:cNvPr>
          <p:cNvSpPr txBox="1"/>
          <p:nvPr/>
        </p:nvSpPr>
        <p:spPr>
          <a:xfrm>
            <a:off x="4270056" y="628064"/>
            <a:ext cx="651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9A77AFBC-A501-43E1-2BE0-19719EE1FCCC}"/>
              </a:ext>
            </a:extLst>
          </p:cNvPr>
          <p:cNvCxnSpPr>
            <a:cxnSpLocks/>
          </p:cNvCxnSpPr>
          <p:nvPr/>
        </p:nvCxnSpPr>
        <p:spPr>
          <a:xfrm>
            <a:off x="3876522" y="922958"/>
            <a:ext cx="27732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AC19DEA4-2E25-0757-05BD-1C55E093D739}"/>
              </a:ext>
            </a:extLst>
          </p:cNvPr>
          <p:cNvCxnSpPr>
            <a:cxnSpLocks/>
          </p:cNvCxnSpPr>
          <p:nvPr/>
        </p:nvCxnSpPr>
        <p:spPr>
          <a:xfrm>
            <a:off x="4400619" y="922958"/>
            <a:ext cx="27732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BF84D7B-54A8-FDAB-E846-C8F57F8CEE2C}"/>
              </a:ext>
            </a:extLst>
          </p:cNvPr>
          <p:cNvSpPr txBox="1"/>
          <p:nvPr/>
        </p:nvSpPr>
        <p:spPr>
          <a:xfrm rot="19091558">
            <a:off x="3689354" y="1003093"/>
            <a:ext cx="5279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Empty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18FE683F-0335-CDB5-2BCD-35A0B1703769}"/>
              </a:ext>
            </a:extLst>
          </p:cNvPr>
          <p:cNvSpPr txBox="1"/>
          <p:nvPr/>
        </p:nvSpPr>
        <p:spPr>
          <a:xfrm>
            <a:off x="542108" y="3989452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591F081-1886-F8A9-EB1F-AA92E686CF95}"/>
              </a:ext>
            </a:extLst>
          </p:cNvPr>
          <p:cNvSpPr txBox="1"/>
          <p:nvPr/>
        </p:nvSpPr>
        <p:spPr>
          <a:xfrm>
            <a:off x="542108" y="4115659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5E6D8487-4A2C-5906-F2E0-ACE1F151FCF9}"/>
              </a:ext>
            </a:extLst>
          </p:cNvPr>
          <p:cNvSpPr txBox="1"/>
          <p:nvPr/>
        </p:nvSpPr>
        <p:spPr>
          <a:xfrm>
            <a:off x="585388" y="4218230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2EEE64C-8B57-C1D9-EB94-3EC2E94BA4AA}"/>
              </a:ext>
            </a:extLst>
          </p:cNvPr>
          <p:cNvSpPr txBox="1"/>
          <p:nvPr/>
        </p:nvSpPr>
        <p:spPr>
          <a:xfrm>
            <a:off x="585388" y="4444073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72C49AD0-BF75-B69E-BA8C-52C37FC14FE6}"/>
              </a:ext>
            </a:extLst>
          </p:cNvPr>
          <p:cNvSpPr txBox="1"/>
          <p:nvPr/>
        </p:nvSpPr>
        <p:spPr>
          <a:xfrm>
            <a:off x="585388" y="4638977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4AD8B81D-3E3D-631C-B008-2299C07C6E32}"/>
              </a:ext>
            </a:extLst>
          </p:cNvPr>
          <p:cNvSpPr txBox="1"/>
          <p:nvPr/>
        </p:nvSpPr>
        <p:spPr>
          <a:xfrm>
            <a:off x="585388" y="5015382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8119D0B5-4D6C-D56E-0976-45D12D23F77A}"/>
              </a:ext>
            </a:extLst>
          </p:cNvPr>
          <p:cNvSpPr txBox="1"/>
          <p:nvPr/>
        </p:nvSpPr>
        <p:spPr>
          <a:xfrm>
            <a:off x="542108" y="3871412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600C8C11-0035-38D1-BB38-6DD662CF0316}"/>
              </a:ext>
            </a:extLst>
          </p:cNvPr>
          <p:cNvSpPr txBox="1"/>
          <p:nvPr/>
        </p:nvSpPr>
        <p:spPr>
          <a:xfrm>
            <a:off x="3014576" y="3149779"/>
            <a:ext cx="7957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l-GR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E2C4FEAD-F563-9D62-8127-6BC6EA8ED9FF}"/>
              </a:ext>
            </a:extLst>
          </p:cNvPr>
          <p:cNvSpPr txBox="1"/>
          <p:nvPr/>
        </p:nvSpPr>
        <p:spPr>
          <a:xfrm rot="19091558">
            <a:off x="3809618" y="3508588"/>
            <a:ext cx="655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F527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874BAEA2-7D06-9BF6-5B48-86B08ED822A5}"/>
              </a:ext>
            </a:extLst>
          </p:cNvPr>
          <p:cNvSpPr txBox="1"/>
          <p:nvPr/>
        </p:nvSpPr>
        <p:spPr>
          <a:xfrm rot="19091558">
            <a:off x="4351845" y="3538570"/>
            <a:ext cx="5279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Empty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DADA0440-416C-1CA2-4287-382F8FDC08D9}"/>
              </a:ext>
            </a:extLst>
          </p:cNvPr>
          <p:cNvSpPr txBox="1"/>
          <p:nvPr/>
        </p:nvSpPr>
        <p:spPr>
          <a:xfrm rot="19091558">
            <a:off x="4459929" y="3506526"/>
            <a:ext cx="6552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F527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30B57598-26B8-C241-AAE8-75FA26A16B2F}"/>
              </a:ext>
            </a:extLst>
          </p:cNvPr>
          <p:cNvSpPr txBox="1"/>
          <p:nvPr/>
        </p:nvSpPr>
        <p:spPr>
          <a:xfrm>
            <a:off x="3777858" y="3237331"/>
            <a:ext cx="5027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ytosol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4051D293-2A29-92F6-2636-B1827E3CE40F}"/>
              </a:ext>
            </a:extLst>
          </p:cNvPr>
          <p:cNvSpPr txBox="1"/>
          <p:nvPr/>
        </p:nvSpPr>
        <p:spPr>
          <a:xfrm>
            <a:off x="4388094" y="3167280"/>
            <a:ext cx="651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4453E0CF-18C2-4029-3765-9DD950745AB7}"/>
              </a:ext>
            </a:extLst>
          </p:cNvPr>
          <p:cNvCxnSpPr>
            <a:cxnSpLocks/>
          </p:cNvCxnSpPr>
          <p:nvPr/>
        </p:nvCxnSpPr>
        <p:spPr>
          <a:xfrm>
            <a:off x="3913761" y="3432832"/>
            <a:ext cx="27732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3C448333-B6E0-FC4C-1F77-DD968811A659}"/>
              </a:ext>
            </a:extLst>
          </p:cNvPr>
          <p:cNvCxnSpPr>
            <a:cxnSpLocks/>
          </p:cNvCxnSpPr>
          <p:nvPr/>
        </p:nvCxnSpPr>
        <p:spPr>
          <a:xfrm>
            <a:off x="4575018" y="3432832"/>
            <a:ext cx="27732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99ECC20F-BC1B-FEE7-88F3-E26BB4305FD2}"/>
              </a:ext>
            </a:extLst>
          </p:cNvPr>
          <p:cNvSpPr txBox="1"/>
          <p:nvPr/>
        </p:nvSpPr>
        <p:spPr>
          <a:xfrm rot="19091558">
            <a:off x="3726593" y="3512967"/>
            <a:ext cx="5279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Empty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8511AD1C-75A7-B275-1850-22A5B25B79A7}"/>
              </a:ext>
            </a:extLst>
          </p:cNvPr>
          <p:cNvSpPr txBox="1"/>
          <p:nvPr/>
        </p:nvSpPr>
        <p:spPr>
          <a:xfrm>
            <a:off x="958736" y="6251645"/>
            <a:ext cx="29177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>
                <a:latin typeface="Arial" panose="020B0604020202020204" pitchFamily="34" charset="0"/>
                <a:cs typeface="Arial" panose="020B0604020202020204" pitchFamily="34" charset="0"/>
              </a:rPr>
              <a:t>Figure S</a:t>
            </a:r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1100" b="1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Uncropped image of figure 3B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1AB13788-4A19-7CA5-FC13-1E4CFEC9C391}"/>
              </a:ext>
            </a:extLst>
          </p:cNvPr>
          <p:cNvSpPr txBox="1"/>
          <p:nvPr/>
        </p:nvSpPr>
        <p:spPr>
          <a:xfrm>
            <a:off x="970082" y="6563465"/>
            <a:ext cx="517839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portion marked by the arrow has been cropped in the main figure. 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線矢印コネクタ 54">
            <a:extLst>
              <a:ext uri="{FF2B5EF4-FFF2-40B4-BE49-F238E27FC236}">
                <a16:creationId xmlns:a16="http://schemas.microsoft.com/office/drawing/2014/main" id="{635ADA9D-3BC1-F8DC-BAD5-1567B126C08F}"/>
              </a:ext>
            </a:extLst>
          </p:cNvPr>
          <p:cNvCxnSpPr>
            <a:cxnSpLocks/>
          </p:cNvCxnSpPr>
          <p:nvPr/>
        </p:nvCxnSpPr>
        <p:spPr>
          <a:xfrm flipH="1">
            <a:off x="4628109" y="1896402"/>
            <a:ext cx="500365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矢印コネクタ 55">
            <a:extLst>
              <a:ext uri="{FF2B5EF4-FFF2-40B4-BE49-F238E27FC236}">
                <a16:creationId xmlns:a16="http://schemas.microsoft.com/office/drawing/2014/main" id="{AFBA9792-1935-95AD-D9A0-27AC2DC1D9D4}"/>
              </a:ext>
            </a:extLst>
          </p:cNvPr>
          <p:cNvCxnSpPr>
            <a:cxnSpLocks/>
          </p:cNvCxnSpPr>
          <p:nvPr/>
        </p:nvCxnSpPr>
        <p:spPr>
          <a:xfrm flipH="1">
            <a:off x="6256020" y="4819173"/>
            <a:ext cx="500365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68798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11</TotalTime>
  <Words>467</Words>
  <Application>Microsoft Office PowerPoint</Application>
  <PresentationFormat>A4 210 x 297 mm</PresentationFormat>
  <Paragraphs>180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琢磨 松原</dc:creator>
  <cp:lastModifiedBy>r15matsubara</cp:lastModifiedBy>
  <cp:revision>49</cp:revision>
  <dcterms:created xsi:type="dcterms:W3CDTF">2019-01-30T01:50:30Z</dcterms:created>
  <dcterms:modified xsi:type="dcterms:W3CDTF">2026-03-09T09:41:29Z</dcterms:modified>
</cp:coreProperties>
</file>